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4"/>
  </p:notesMasterIdLst>
  <p:sldIdLst>
    <p:sldId id="269" r:id="rId2"/>
    <p:sldId id="273" r:id="rId3"/>
    <p:sldId id="259" r:id="rId4"/>
    <p:sldId id="279" r:id="rId5"/>
    <p:sldId id="284" r:id="rId6"/>
    <p:sldId id="285" r:id="rId7"/>
    <p:sldId id="261" r:id="rId8"/>
    <p:sldId id="282" r:id="rId9"/>
    <p:sldId id="276" r:id="rId10"/>
    <p:sldId id="280" r:id="rId11"/>
    <p:sldId id="281" r:id="rId12"/>
    <p:sldId id="283" r:id="rId1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02B7667-0A3E-8D09-DF4A-2530FF69CA01}" name="Ebene Haycroft" initials="EH" userId="S::ehaycroft@student.unimelb.edu.au::eeca8874-0458-41d1-aeca-64044f1da89a" providerId="AD"/>
  <p188:author id="{181B78F7-D58B-0415-0C8D-24C9A7EC9284}" name="Amy Chung" initials="AC" userId="S::awchung@unimelb.edu.au::d5b11f71-e7fe-4fd4-aaf9-ff0721f21a5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78"/>
    <p:restoredTop sz="96327"/>
  </p:normalViewPr>
  <p:slideViewPr>
    <p:cSldViewPr snapToGrid="0" snapToObjects="1">
      <p:cViewPr varScale="1">
        <p:scale>
          <a:sx n="85" d="100"/>
          <a:sy n="85" d="100"/>
        </p:scale>
        <p:origin x="26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my Chung" userId="d5b11f71-e7fe-4fd4-aaf9-ff0721f21a57" providerId="ADAL" clId="{49CC419D-4BFC-DF4A-A329-3665A39C6700}"/>
    <pc:docChg chg="">
      <pc:chgData name="Amy Chung" userId="d5b11f71-e7fe-4fd4-aaf9-ff0721f21a57" providerId="ADAL" clId="{49CC419D-4BFC-DF4A-A329-3665A39C6700}" dt="2023-06-13T07:14:00.836" v="0"/>
      <pc:docMkLst>
        <pc:docMk/>
      </pc:docMkLst>
      <pc:sldChg chg="delCm">
        <pc:chgData name="Amy Chung" userId="d5b11f71-e7fe-4fd4-aaf9-ff0721f21a57" providerId="ADAL" clId="{49CC419D-4BFC-DF4A-A329-3665A39C6700}" dt="2023-06-13T07:14:00.836" v="0"/>
        <pc:sldMkLst>
          <pc:docMk/>
          <pc:sldMk cId="4151016709" sldId="273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Amy Chung" userId="d5b11f71-e7fe-4fd4-aaf9-ff0721f21a57" providerId="ADAL" clId="{49CC419D-4BFC-DF4A-A329-3665A39C6700}" dt="2023-06-13T07:14:00.836" v="0"/>
              <pc2:cmMkLst xmlns:pc2="http://schemas.microsoft.com/office/powerpoint/2019/9/main/command">
                <pc:docMk/>
                <pc:sldMk cId="4151016709" sldId="273"/>
                <pc2:cmMk id="{A3C88D94-8C90-6C47-B209-43425204790A}"/>
              </pc2:cmMkLst>
            </pc226:cmChg>
          </p:ext>
        </pc:ext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ehaycroft\Documents\Masters\2021:2022\COVID-19\Pfizer%20Vaccine%20Study\Analysis\SARS-CoV-2%20antigens%20analysis%20(trimer,%20NP,%20S1,%20RBD)\Radar%20Plot\Radar%20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ehaycroft\Documents\Masters\2021:2022\COVID-19\Pfizer%20Vaccine%20Study\Analysis\SARS-CoV-2%20antigens%20analysis%20(trimer,%20NP,%20S1,%20RBD)\Radar%20Plot\Radar%20Plo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ehaycroft\Documents\Masters\2021:2022\COVID-19\Pfizer%20Vaccine%20Study\Analysis\SARS-CoV-2%20antigens%20analysis%20(trimer,%20NP,%20S1,%20RBD)\Radar%20Plot\Radar%20Plo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ehaycroft\Documents\Masters\2021:2022\COVID-19\Pfizer%20Vaccine%20Study\Analysis\SARS-CoV-2%20antigens%20analysis%20(trimer,%20NP,%20S1,%20RBD)\Radar%20Plot\Radar%20Plot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r>
              <a:rPr lang="en-GB" sz="1600" b="1">
                <a:solidFill>
                  <a:schemeClr val="tx1"/>
                </a:solidFill>
                <a:latin typeface="Times" pitchFamily="2" charset="0"/>
                <a:cs typeface="Arial" panose="020B0604020202020204" pitchFamily="34" charset="0"/>
              </a:rPr>
              <a:t>Trimeric Spik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" pitchFamily="2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'Trimer (Z-score)'!$B$1</c:f>
              <c:strCache>
                <c:ptCount val="1"/>
                <c:pt idx="0">
                  <c:v>2-Week Post Boost</c:v>
                </c:pt>
              </c:strCache>
            </c:strRef>
          </c:tx>
          <c:spPr>
            <a:ln w="28575" cap="rnd">
              <a:solidFill>
                <a:srgbClr val="21729D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21729D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Trimer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Trimer (Z-score)'!$B$2:$B$10</c:f>
              <c:numCache>
                <c:formatCode>0.000</c:formatCode>
                <c:ptCount val="9"/>
                <c:pt idx="0">
                  <c:v>0.907764091555055</c:v>
                </c:pt>
                <c:pt idx="1">
                  <c:v>0.72720112119396296</c:v>
                </c:pt>
                <c:pt idx="2">
                  <c:v>0.23815429331068799</c:v>
                </c:pt>
                <c:pt idx="3">
                  <c:v>1.0140929751711301</c:v>
                </c:pt>
                <c:pt idx="4">
                  <c:v>1.1535045350514199</c:v>
                </c:pt>
                <c:pt idx="5">
                  <c:v>1.15390613046613</c:v>
                </c:pt>
                <c:pt idx="6">
                  <c:v>1.1522771695021501</c:v>
                </c:pt>
                <c:pt idx="7">
                  <c:v>1.0760025711119099</c:v>
                </c:pt>
                <c:pt idx="8">
                  <c:v>1.069537586325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16-7641-A7E5-AC38DC7B6442}"/>
            </c:ext>
          </c:extLst>
        </c:ser>
        <c:ser>
          <c:idx val="1"/>
          <c:order val="1"/>
          <c:tx>
            <c:strRef>
              <c:f>'Trimer (Z-score)'!$C$1</c:f>
              <c:strCache>
                <c:ptCount val="1"/>
                <c:pt idx="0">
                  <c:v>Convalescent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accent6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Trimer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Trimer (Z-score)'!$C$2:$C$10</c:f>
              <c:numCache>
                <c:formatCode>0.000</c:formatCode>
                <c:ptCount val="9"/>
                <c:pt idx="0">
                  <c:v>0.16415781180644701</c:v>
                </c:pt>
                <c:pt idx="1">
                  <c:v>0.41317733365637799</c:v>
                </c:pt>
                <c:pt idx="2">
                  <c:v>0.85942267420987495</c:v>
                </c:pt>
                <c:pt idx="3">
                  <c:v>-2.88084942376742E-2</c:v>
                </c:pt>
                <c:pt idx="4">
                  <c:v>-0.53124989712752602</c:v>
                </c:pt>
                <c:pt idx="5">
                  <c:v>-0.53986558008618502</c:v>
                </c:pt>
                <c:pt idx="6">
                  <c:v>-0.51138525678193603</c:v>
                </c:pt>
                <c:pt idx="7">
                  <c:v>-0.175146148868565</c:v>
                </c:pt>
                <c:pt idx="8">
                  <c:v>-0.15785101223849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216-7641-A7E5-AC38DC7B6442}"/>
            </c:ext>
          </c:extLst>
        </c:ser>
        <c:ser>
          <c:idx val="2"/>
          <c:order val="2"/>
          <c:tx>
            <c:strRef>
              <c:f>'Trimer (Z-score)'!$D$1</c:f>
              <c:strCache>
                <c:ptCount val="1"/>
                <c:pt idx="0">
                  <c:v>Baseline</c:v>
                </c:pt>
              </c:strCache>
            </c:strRef>
          </c:tx>
          <c:spPr>
            <a:ln w="28575" cap="rnd">
              <a:solidFill>
                <a:srgbClr val="AB70D6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AB70D6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Trimer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Trimer (Z-score)'!$D$2:$D$10</c:f>
              <c:numCache>
                <c:formatCode>0.000</c:formatCode>
                <c:ptCount val="9"/>
                <c:pt idx="0">
                  <c:v>-1.0719219033615</c:v>
                </c:pt>
                <c:pt idx="1">
                  <c:v>-1.14037845485034</c:v>
                </c:pt>
                <c:pt idx="2">
                  <c:v>-1.09757696752056</c:v>
                </c:pt>
                <c:pt idx="3">
                  <c:v>-0.98528448093345899</c:v>
                </c:pt>
                <c:pt idx="4">
                  <c:v>-0.62225463792389601</c:v>
                </c:pt>
                <c:pt idx="5">
                  <c:v>-0.61404055037994099</c:v>
                </c:pt>
                <c:pt idx="6">
                  <c:v>-0.64089191272021795</c:v>
                </c:pt>
                <c:pt idx="7">
                  <c:v>-0.90085642224334295</c:v>
                </c:pt>
                <c:pt idx="8">
                  <c:v>-0.91168657408746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216-7641-A7E5-AC38DC7B64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0174495"/>
        <c:axId val="1811394159"/>
      </c:radarChart>
      <c:catAx>
        <c:axId val="1930174495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11394159"/>
        <c:crosses val="autoZero"/>
        <c:auto val="1"/>
        <c:lblAlgn val="ctr"/>
        <c:lblOffset val="100"/>
        <c:noMultiLvlLbl val="0"/>
      </c:catAx>
      <c:valAx>
        <c:axId val="181139415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01744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r>
              <a:rPr lang="en-GB" sz="1600" b="1">
                <a:solidFill>
                  <a:schemeClr val="tx1"/>
                </a:solidFill>
                <a:latin typeface="Times" pitchFamily="2" charset="0"/>
                <a:cs typeface="Arial" panose="020B0604020202020204" pitchFamily="34" charset="0"/>
              </a:rPr>
              <a:t>S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" pitchFamily="2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'S1 (Z-score)'!$B$1</c:f>
              <c:strCache>
                <c:ptCount val="1"/>
                <c:pt idx="0">
                  <c:v>2-Week Post Boost</c:v>
                </c:pt>
              </c:strCache>
            </c:strRef>
          </c:tx>
          <c:spPr>
            <a:ln w="28575" cap="rnd">
              <a:solidFill>
                <a:srgbClr val="21729D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21729D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S1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S1 (Z-score)'!$B$2:$B$10</c:f>
              <c:numCache>
                <c:formatCode>0.000</c:formatCode>
                <c:ptCount val="9"/>
                <c:pt idx="0">
                  <c:v>1.1172851995573101</c:v>
                </c:pt>
                <c:pt idx="1">
                  <c:v>0.69247144940194905</c:v>
                </c:pt>
                <c:pt idx="2">
                  <c:v>0.89018396395120503</c:v>
                </c:pt>
                <c:pt idx="3">
                  <c:v>1.02852108316476</c:v>
                </c:pt>
                <c:pt idx="4">
                  <c:v>1.15419186385303</c:v>
                </c:pt>
                <c:pt idx="5">
                  <c:v>1.1541163175165301</c:v>
                </c:pt>
                <c:pt idx="6">
                  <c:v>1.1543815032017699</c:v>
                </c:pt>
                <c:pt idx="7">
                  <c:v>1.1468882569446801</c:v>
                </c:pt>
                <c:pt idx="8">
                  <c:v>1.1399539895180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13-0640-B903-68649D062D84}"/>
            </c:ext>
          </c:extLst>
        </c:ser>
        <c:ser>
          <c:idx val="1"/>
          <c:order val="1"/>
          <c:tx>
            <c:strRef>
              <c:f>'S1 (Z-score)'!$C$1</c:f>
              <c:strCache>
                <c:ptCount val="1"/>
                <c:pt idx="0">
                  <c:v>Convalescent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rgbClr val="D1E9D6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S1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S1 (Z-score)'!$C$2:$C$10</c:f>
              <c:numCache>
                <c:formatCode>0.000</c:formatCode>
                <c:ptCount val="9"/>
                <c:pt idx="0">
                  <c:v>-0.30614440743337001</c:v>
                </c:pt>
                <c:pt idx="1">
                  <c:v>0.45399078624600397</c:v>
                </c:pt>
                <c:pt idx="2">
                  <c:v>0.19183767092422199</c:v>
                </c:pt>
                <c:pt idx="3">
                  <c:v>-5.9718699598407303E-2</c:v>
                </c:pt>
                <c:pt idx="4">
                  <c:v>-0.547416712570296</c:v>
                </c:pt>
                <c:pt idx="5">
                  <c:v>-0.54525180355111702</c:v>
                </c:pt>
                <c:pt idx="6">
                  <c:v>-0.55368524587958301</c:v>
                </c:pt>
                <c:pt idx="7">
                  <c:v>-0.45731706633003999</c:v>
                </c:pt>
                <c:pt idx="8">
                  <c:v>-0.41067013258304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13-0640-B903-68649D062D84}"/>
            </c:ext>
          </c:extLst>
        </c:ser>
        <c:ser>
          <c:idx val="2"/>
          <c:order val="2"/>
          <c:tx>
            <c:strRef>
              <c:f>'S1 (Z-score)'!$D$1</c:f>
              <c:strCache>
                <c:ptCount val="1"/>
                <c:pt idx="0">
                  <c:v>Baseline</c:v>
                </c:pt>
              </c:strCache>
            </c:strRef>
          </c:tx>
          <c:spPr>
            <a:ln w="28575" cap="rnd">
              <a:solidFill>
                <a:srgbClr val="AB70D6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AB70D6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S1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S1 (Z-score)'!$D$2:$D$10</c:f>
              <c:numCache>
                <c:formatCode>0.000</c:formatCode>
                <c:ptCount val="9"/>
                <c:pt idx="0">
                  <c:v>-0.81114079212393997</c:v>
                </c:pt>
                <c:pt idx="1">
                  <c:v>-1.1464622356479499</c:v>
                </c:pt>
                <c:pt idx="2">
                  <c:v>-1.0820216348754299</c:v>
                </c:pt>
                <c:pt idx="3">
                  <c:v>-0.96880238356635695</c:v>
                </c:pt>
                <c:pt idx="4">
                  <c:v>-0.60677515128273796</c:v>
                </c:pt>
                <c:pt idx="5">
                  <c:v>-0.60886451396541297</c:v>
                </c:pt>
                <c:pt idx="6">
                  <c:v>-0.60069625732218901</c:v>
                </c:pt>
                <c:pt idx="7">
                  <c:v>-0.68957119061463601</c:v>
                </c:pt>
                <c:pt idx="8">
                  <c:v>-0.729283856935035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F13-0640-B903-68649D062D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9886591"/>
        <c:axId val="1855512351"/>
      </c:radarChart>
      <c:catAx>
        <c:axId val="192988659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55512351"/>
        <c:crosses val="autoZero"/>
        <c:auto val="1"/>
        <c:lblAlgn val="ctr"/>
        <c:lblOffset val="100"/>
        <c:noMultiLvlLbl val="0"/>
      </c:catAx>
      <c:valAx>
        <c:axId val="185551235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98865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r>
              <a:rPr lang="en-GB" sz="1600" b="1">
                <a:solidFill>
                  <a:schemeClr val="tx1"/>
                </a:solidFill>
                <a:latin typeface="Times" pitchFamily="2" charset="0"/>
                <a:cs typeface="Arial" panose="020B0604020202020204" pitchFamily="34" charset="0"/>
              </a:rPr>
              <a:t>RBD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" pitchFamily="2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'RBD (Z-score)'!$B$1</c:f>
              <c:strCache>
                <c:ptCount val="1"/>
                <c:pt idx="0">
                  <c:v>2-Week Post Boost</c:v>
                </c:pt>
              </c:strCache>
            </c:strRef>
          </c:tx>
          <c:spPr>
            <a:ln w="28575" cap="rnd">
              <a:solidFill>
                <a:srgbClr val="21729D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21729D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RBD (Z-score)'!$A$2:$A$10</c:f>
              <c:strCache>
                <c:ptCount val="9"/>
                <c:pt idx="0">
                  <c:v>Pan IgG   </c:v>
                </c:pt>
                <c:pt idx="1">
                  <c:v>IgA1   </c:v>
                </c:pt>
                <c:pt idx="2">
                  <c:v>IgM 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RBD (Z-score)'!$B$2:$B$10</c:f>
              <c:numCache>
                <c:formatCode>0.000</c:formatCode>
                <c:ptCount val="9"/>
                <c:pt idx="0">
                  <c:v>1.10871237855634</c:v>
                </c:pt>
                <c:pt idx="1">
                  <c:v>0.32958118824521598</c:v>
                </c:pt>
                <c:pt idx="2">
                  <c:v>-5.4159855691272997E-2</c:v>
                </c:pt>
                <c:pt idx="3">
                  <c:v>1.1305191218794199</c:v>
                </c:pt>
                <c:pt idx="4">
                  <c:v>1.1532892110581401</c:v>
                </c:pt>
                <c:pt idx="5">
                  <c:v>1.1543472208519701</c:v>
                </c:pt>
                <c:pt idx="6">
                  <c:v>1.14799360533468</c:v>
                </c:pt>
                <c:pt idx="7">
                  <c:v>1.1510799067353601</c:v>
                </c:pt>
                <c:pt idx="8">
                  <c:v>1.1296482554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B6-0B42-A142-DEC61DE343CA}"/>
            </c:ext>
          </c:extLst>
        </c:ser>
        <c:ser>
          <c:idx val="1"/>
          <c:order val="1"/>
          <c:tx>
            <c:strRef>
              <c:f>'RBD (Z-score)'!$C$1</c:f>
              <c:strCache>
                <c:ptCount val="1"/>
                <c:pt idx="0">
                  <c:v>Convalescent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RBD (Z-score)'!$A$2:$A$10</c:f>
              <c:strCache>
                <c:ptCount val="9"/>
                <c:pt idx="0">
                  <c:v>Pan IgG   </c:v>
                </c:pt>
                <c:pt idx="1">
                  <c:v>IgA1   </c:v>
                </c:pt>
                <c:pt idx="2">
                  <c:v>IgM 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RBD (Z-score)'!$C$2:$C$10</c:f>
              <c:numCache>
                <c:formatCode>0.000</c:formatCode>
                <c:ptCount val="9"/>
                <c:pt idx="0">
                  <c:v>-0.27495030847577101</c:v>
                </c:pt>
                <c:pt idx="1">
                  <c:v>0.79361025117447004</c:v>
                </c:pt>
                <c:pt idx="2">
                  <c:v>1.02597933845895</c:v>
                </c:pt>
                <c:pt idx="3">
                  <c:v>-0.36167938926591198</c:v>
                </c:pt>
                <c:pt idx="4">
                  <c:v>-0.52721792505514897</c:v>
                </c:pt>
                <c:pt idx="5">
                  <c:v>-0.55243759855058605</c:v>
                </c:pt>
                <c:pt idx="6">
                  <c:v>-0.46637240216721398</c:v>
                </c:pt>
                <c:pt idx="7">
                  <c:v>-0.49641166365673201</c:v>
                </c:pt>
                <c:pt idx="8">
                  <c:v>-0.35765001210862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B6-0B42-A142-DEC61DE343CA}"/>
            </c:ext>
          </c:extLst>
        </c:ser>
        <c:ser>
          <c:idx val="2"/>
          <c:order val="2"/>
          <c:tx>
            <c:strRef>
              <c:f>'RBD (Z-score)'!$D$1</c:f>
              <c:strCache>
                <c:ptCount val="1"/>
                <c:pt idx="0">
                  <c:v>Baseline</c:v>
                </c:pt>
              </c:strCache>
            </c:strRef>
          </c:tx>
          <c:spPr>
            <a:ln w="28575" cap="rnd">
              <a:solidFill>
                <a:srgbClr val="AB70D6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AB70D6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RBD (Z-score)'!$A$2:$A$10</c:f>
              <c:strCache>
                <c:ptCount val="9"/>
                <c:pt idx="0">
                  <c:v>Pan IgG   </c:v>
                </c:pt>
                <c:pt idx="1">
                  <c:v>IgA1   </c:v>
                </c:pt>
                <c:pt idx="2">
                  <c:v>IgM 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RBD (Z-score)'!$D$2:$D$10</c:f>
              <c:numCache>
                <c:formatCode>0.000</c:formatCode>
                <c:ptCount val="9"/>
                <c:pt idx="0">
                  <c:v>-0.83376207008056602</c:v>
                </c:pt>
                <c:pt idx="1">
                  <c:v>-1.12319143941969</c:v>
                </c:pt>
                <c:pt idx="2">
                  <c:v>-0.97181948276767705</c:v>
                </c:pt>
                <c:pt idx="3">
                  <c:v>-0.76883973261351102</c:v>
                </c:pt>
                <c:pt idx="4">
                  <c:v>-0.62607128600299</c:v>
                </c:pt>
                <c:pt idx="5">
                  <c:v>-0.60190962230138501</c:v>
                </c:pt>
                <c:pt idx="6">
                  <c:v>-0.68162120316746699</c:v>
                </c:pt>
                <c:pt idx="7">
                  <c:v>-0.65466824307863203</c:v>
                </c:pt>
                <c:pt idx="8">
                  <c:v>-0.77199824336117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B6-0B42-A142-DEC61DE343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7390480"/>
        <c:axId val="1808175615"/>
      </c:radarChart>
      <c:catAx>
        <c:axId val="1673904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08175615"/>
        <c:crosses val="autoZero"/>
        <c:auto val="1"/>
        <c:lblAlgn val="ctr"/>
        <c:lblOffset val="100"/>
        <c:noMultiLvlLbl val="0"/>
      </c:catAx>
      <c:valAx>
        <c:axId val="18081756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7390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r>
              <a:rPr lang="en-GB" sz="1600" b="1">
                <a:solidFill>
                  <a:schemeClr val="tx1"/>
                </a:solidFill>
                <a:latin typeface="Times" pitchFamily="2" charset="0"/>
                <a:cs typeface="Arial" panose="020B0604020202020204" pitchFamily="34" charset="0"/>
              </a:rPr>
              <a:t>N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Times" pitchFamily="2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'NP (Z-score)'!$B$1</c:f>
              <c:strCache>
                <c:ptCount val="1"/>
                <c:pt idx="0">
                  <c:v>2-Week Post Boost</c:v>
                </c:pt>
              </c:strCache>
            </c:strRef>
          </c:tx>
          <c:spPr>
            <a:ln w="28575" cap="rnd">
              <a:solidFill>
                <a:srgbClr val="21729D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rgbClr val="21729D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NP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NP (Z-score)'!$B$2:$B$10</c:f>
              <c:numCache>
                <c:formatCode>0.000</c:formatCode>
                <c:ptCount val="9"/>
                <c:pt idx="0">
                  <c:v>-0.56672924211803699</c:v>
                </c:pt>
                <c:pt idx="1">
                  <c:v>0.153361708279312</c:v>
                </c:pt>
                <c:pt idx="2">
                  <c:v>-0.64953229004701196</c:v>
                </c:pt>
                <c:pt idx="3">
                  <c:v>-0.57934831661981501</c:v>
                </c:pt>
                <c:pt idx="4">
                  <c:v>-0.571346752758778</c:v>
                </c:pt>
                <c:pt idx="5">
                  <c:v>-0.57507952811124297</c:v>
                </c:pt>
                <c:pt idx="6">
                  <c:v>-0.27735009811261502</c:v>
                </c:pt>
                <c:pt idx="7">
                  <c:v>-0.57596073941987502</c:v>
                </c:pt>
                <c:pt idx="8">
                  <c:v>-0.5805157410182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F8-A948-B2E4-31263D56ED66}"/>
            </c:ext>
          </c:extLst>
        </c:ser>
        <c:ser>
          <c:idx val="1"/>
          <c:order val="1"/>
          <c:tx>
            <c:strRef>
              <c:f>'NP (Z-score)'!$C$1</c:f>
              <c:strCache>
                <c:ptCount val="1"/>
                <c:pt idx="0">
                  <c:v>Convalescent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accent6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NP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NP (Z-score)'!$C$2:$C$10</c:f>
              <c:numCache>
                <c:formatCode>0.000</c:formatCode>
                <c:ptCount val="9"/>
                <c:pt idx="0">
                  <c:v>1.1546358042139699</c:v>
                </c:pt>
                <c:pt idx="1">
                  <c:v>0.91445997330377005</c:v>
                </c:pt>
                <c:pt idx="2">
                  <c:v>1.1515556304064001</c:v>
                </c:pt>
                <c:pt idx="3">
                  <c:v>1.15469823082023</c:v>
                </c:pt>
                <c:pt idx="4">
                  <c:v>1.1546798010299799</c:v>
                </c:pt>
                <c:pt idx="5">
                  <c:v>1.15469756530088</c:v>
                </c:pt>
                <c:pt idx="6">
                  <c:v>1.1094003924504601</c:v>
                </c:pt>
                <c:pt idx="7">
                  <c:v>1.15469942452827</c:v>
                </c:pt>
                <c:pt idx="8">
                  <c:v>1.15469474259553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DF8-A948-B2E4-31263D56ED66}"/>
            </c:ext>
          </c:extLst>
        </c:ser>
        <c:ser>
          <c:idx val="2"/>
          <c:order val="2"/>
          <c:tx>
            <c:strRef>
              <c:f>'NP (Z-score)'!$D$1</c:f>
              <c:strCache>
                <c:ptCount val="1"/>
                <c:pt idx="0">
                  <c:v>Baseline</c:v>
                </c:pt>
              </c:strCache>
            </c:strRef>
          </c:tx>
          <c:spPr>
            <a:ln w="28575" cap="rnd">
              <a:solidFill>
                <a:srgbClr val="AB70D6"/>
              </a:solidFill>
              <a:round/>
            </a:ln>
            <a:effectLst/>
          </c:spPr>
          <c:marker>
            <c:symbol val="triangle"/>
            <c:size val="7"/>
            <c:spPr>
              <a:solidFill>
                <a:srgbClr val="AB70D6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'NP (Z-score)'!$A$2:$A$10</c:f>
              <c:strCache>
                <c:ptCount val="9"/>
                <c:pt idx="0">
                  <c:v>Pan IgG  </c:v>
                </c:pt>
                <c:pt idx="1">
                  <c:v>IgA1  </c:v>
                </c:pt>
                <c:pt idx="2">
                  <c:v>IgM  </c:v>
                </c:pt>
                <c:pt idx="3">
                  <c:v>IgG1  </c:v>
                </c:pt>
                <c:pt idx="4">
                  <c:v>IgG2  </c:v>
                </c:pt>
                <c:pt idx="5">
                  <c:v>IgG3  </c:v>
                </c:pt>
                <c:pt idx="6">
                  <c:v>IgG4  </c:v>
                </c:pt>
                <c:pt idx="7">
                  <c:v>FcgR2a  </c:v>
                </c:pt>
                <c:pt idx="8">
                  <c:v>FcgR3a  </c:v>
                </c:pt>
              </c:strCache>
            </c:strRef>
          </c:cat>
          <c:val>
            <c:numRef>
              <c:f>'NP (Z-score)'!$D$2:$D$10</c:f>
              <c:numCache>
                <c:formatCode>0.000</c:formatCode>
                <c:ptCount val="9"/>
                <c:pt idx="0">
                  <c:v>-0.58790656209593695</c:v>
                </c:pt>
                <c:pt idx="1">
                  <c:v>-1.0678216815830801</c:v>
                </c:pt>
                <c:pt idx="2">
                  <c:v>-0.50202334035939</c:v>
                </c:pt>
                <c:pt idx="3">
                  <c:v>-0.57534991420041304</c:v>
                </c:pt>
                <c:pt idx="4">
                  <c:v>-0.58333304827120003</c:v>
                </c:pt>
                <c:pt idx="5">
                  <c:v>-0.579618037189638</c:v>
                </c:pt>
                <c:pt idx="6">
                  <c:v>-0.83205029433784405</c:v>
                </c:pt>
                <c:pt idx="7">
                  <c:v>-0.57873868510839499</c:v>
                </c:pt>
                <c:pt idx="8">
                  <c:v>-0.57417900157722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F8-A948-B2E4-31263D56ED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25898447"/>
        <c:axId val="1826136639"/>
      </c:radarChart>
      <c:catAx>
        <c:axId val="182589844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6136639"/>
        <c:crosses val="autoZero"/>
        <c:auto val="1"/>
        <c:lblAlgn val="ctr"/>
        <c:lblOffset val="100"/>
        <c:noMultiLvlLbl val="0"/>
      </c:catAx>
      <c:valAx>
        <c:axId val="18261366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58984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F4AD32-0DCE-6D4D-88A0-B3CCC0D2B8AE}" type="datetimeFigureOut">
              <a:rPr lang="en-US" smtClean="0"/>
              <a:t>6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9478BD-32F8-F848-9024-26130F8882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87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Decimals change to 1 decimal poi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4C0BC9-4976-1B44-A22A-A6A0D6722BAB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99374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Asterisks for significance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4C0BC9-4976-1B44-A22A-A6A0D6722BAB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352390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4C0BC9-4976-1B44-A22A-A6A0D6722BAB}" type="slidenum">
              <a:rPr lang="en-AU" smtClean="0"/>
              <a:t>9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33348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93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927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862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392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599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850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746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044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012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720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72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D5BA3-096D-164B-8CD6-7FE3CCC6F0FA}" type="datetimeFigureOut">
              <a:rPr lang="en-US" smtClean="0"/>
              <a:t>6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308F3-05CA-B04D-92E3-0A004B9B3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357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chart" Target="../charts/chart1.xml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4">
            <a:extLst>
              <a:ext uri="{FF2B5EF4-FFF2-40B4-BE49-F238E27FC236}">
                <a16:creationId xmlns:a16="http://schemas.microsoft.com/office/drawing/2014/main" id="{824C90A7-7853-2544-8D53-794618335876}"/>
              </a:ext>
            </a:extLst>
          </p:cNvPr>
          <p:cNvSpPr txBox="1"/>
          <p:nvPr/>
        </p:nvSpPr>
        <p:spPr>
          <a:xfrm>
            <a:off x="30088" y="9367224"/>
            <a:ext cx="6065294" cy="549804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AU" sz="1089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endParaRPr lang="en-AU" sz="108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9A9B83-D9FE-7CF5-B33F-4F48691CC256}"/>
              </a:ext>
            </a:extLst>
          </p:cNvPr>
          <p:cNvSpPr txBox="1"/>
          <p:nvPr/>
        </p:nvSpPr>
        <p:spPr>
          <a:xfrm>
            <a:off x="30088" y="4851931"/>
            <a:ext cx="296876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 dirty="0"/>
              <a:t>C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6866839-8DDE-FE5D-8528-F81845E6C876}"/>
              </a:ext>
            </a:extLst>
          </p:cNvPr>
          <p:cNvGrpSpPr/>
          <p:nvPr/>
        </p:nvGrpSpPr>
        <p:grpSpPr>
          <a:xfrm>
            <a:off x="0" y="67231"/>
            <a:ext cx="7036526" cy="9196858"/>
            <a:chOff x="0" y="67231"/>
            <a:chExt cx="7036526" cy="9196858"/>
          </a:xfrm>
        </p:grpSpPr>
        <p:pic>
          <p:nvPicPr>
            <p:cNvPr id="41" name="Picture 40" descr="Graphical user interface, calendar&#10;&#10;Description automatically generated">
              <a:extLst>
                <a:ext uri="{FF2B5EF4-FFF2-40B4-BE49-F238E27FC236}">
                  <a16:creationId xmlns:a16="http://schemas.microsoft.com/office/drawing/2014/main" id="{82FAAD87-67A2-DF62-5924-764B506F7E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6964" y="3054875"/>
              <a:ext cx="6521837" cy="3482604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117C242-94FC-E903-BEC3-4588FDE0EECB}"/>
                </a:ext>
              </a:extLst>
            </p:cNvPr>
            <p:cNvSpPr txBox="1"/>
            <p:nvPr/>
          </p:nvSpPr>
          <p:spPr>
            <a:xfrm>
              <a:off x="30088" y="3106345"/>
              <a:ext cx="298480" cy="3436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1633" dirty="0"/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3FFADFA-0767-6A7F-7DDD-210ACD2305EC}"/>
                </a:ext>
              </a:extLst>
            </p:cNvPr>
            <p:cNvSpPr txBox="1"/>
            <p:nvPr/>
          </p:nvSpPr>
          <p:spPr>
            <a:xfrm>
              <a:off x="20470" y="67231"/>
              <a:ext cx="306494" cy="3436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1633" dirty="0"/>
                <a:t>A</a:t>
              </a:r>
            </a:p>
          </p:txBody>
        </p:sp>
        <p:pic>
          <p:nvPicPr>
            <p:cNvPr id="8" name="Picture 7" descr="Graphical user interface&#10;&#10;Description automatically generated with medium confidence">
              <a:extLst>
                <a:ext uri="{FF2B5EF4-FFF2-40B4-BE49-F238E27FC236}">
                  <a16:creationId xmlns:a16="http://schemas.microsoft.com/office/drawing/2014/main" id="{1ABE3443-491F-C444-3B70-CB0083D40EB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8526" y="193003"/>
              <a:ext cx="6858000" cy="286603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F3EDBDA-1094-D56B-A311-D303A61C7AE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6597517"/>
              <a:ext cx="6716638" cy="2666572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6EF10FC-D2CD-74D8-4E63-816054286C61}"/>
                </a:ext>
              </a:extLst>
            </p:cNvPr>
            <p:cNvSpPr txBox="1"/>
            <p:nvPr/>
          </p:nvSpPr>
          <p:spPr>
            <a:xfrm>
              <a:off x="30088" y="6494382"/>
              <a:ext cx="312906" cy="3436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1633" dirty="0"/>
                <a:t>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7088AB1-6D27-38DF-02A8-3296678B5212}"/>
                </a:ext>
              </a:extLst>
            </p:cNvPr>
            <p:cNvSpPr txBox="1"/>
            <p:nvPr/>
          </p:nvSpPr>
          <p:spPr>
            <a:xfrm>
              <a:off x="2239888" y="6494382"/>
              <a:ext cx="287258" cy="3436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1633" dirty="0"/>
                <a:t>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BC05631-E3D0-675C-D372-F2F621A17EAA}"/>
                </a:ext>
              </a:extLst>
            </p:cNvPr>
            <p:cNvSpPr txBox="1"/>
            <p:nvPr/>
          </p:nvSpPr>
          <p:spPr>
            <a:xfrm>
              <a:off x="4547550" y="6430342"/>
              <a:ext cx="280846" cy="3436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AU" sz="1633" dirty="0"/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175077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439F4E4-EC88-481F-FAFB-A5EB284C25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2618594"/>
              </p:ext>
            </p:extLst>
          </p:nvPr>
        </p:nvGraphicFramePr>
        <p:xfrm>
          <a:off x="222069" y="1188266"/>
          <a:ext cx="6295592" cy="5558469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745709">
                  <a:extLst>
                    <a:ext uri="{9D8B030D-6E8A-4147-A177-3AD203B41FA5}">
                      <a16:colId xmlns:a16="http://schemas.microsoft.com/office/drawing/2014/main" val="2413106901"/>
                    </a:ext>
                  </a:extLst>
                </a:gridCol>
                <a:gridCol w="673991">
                  <a:extLst>
                    <a:ext uri="{9D8B030D-6E8A-4147-A177-3AD203B41FA5}">
                      <a16:colId xmlns:a16="http://schemas.microsoft.com/office/drawing/2014/main" val="106180607"/>
                    </a:ext>
                  </a:extLst>
                </a:gridCol>
                <a:gridCol w="551388">
                  <a:extLst>
                    <a:ext uri="{9D8B030D-6E8A-4147-A177-3AD203B41FA5}">
                      <a16:colId xmlns:a16="http://schemas.microsoft.com/office/drawing/2014/main" val="3291140751"/>
                    </a:ext>
                  </a:extLst>
                </a:gridCol>
                <a:gridCol w="915934">
                  <a:extLst>
                    <a:ext uri="{9D8B030D-6E8A-4147-A177-3AD203B41FA5}">
                      <a16:colId xmlns:a16="http://schemas.microsoft.com/office/drawing/2014/main" val="2902735920"/>
                    </a:ext>
                  </a:extLst>
                </a:gridCol>
                <a:gridCol w="650472">
                  <a:extLst>
                    <a:ext uri="{9D8B030D-6E8A-4147-A177-3AD203B41FA5}">
                      <a16:colId xmlns:a16="http://schemas.microsoft.com/office/drawing/2014/main" val="2735903395"/>
                    </a:ext>
                  </a:extLst>
                </a:gridCol>
                <a:gridCol w="879049">
                  <a:extLst>
                    <a:ext uri="{9D8B030D-6E8A-4147-A177-3AD203B41FA5}">
                      <a16:colId xmlns:a16="http://schemas.microsoft.com/office/drawing/2014/main" val="3353764847"/>
                    </a:ext>
                  </a:extLst>
                </a:gridCol>
                <a:gridCol w="879049">
                  <a:extLst>
                    <a:ext uri="{9D8B030D-6E8A-4147-A177-3AD203B41FA5}">
                      <a16:colId xmlns:a16="http://schemas.microsoft.com/office/drawing/2014/main" val="1138119215"/>
                    </a:ext>
                  </a:extLst>
                </a:gridCol>
              </a:tblGrid>
              <a:tr h="119927">
                <a:tc gridSpan="7">
                  <a:txBody>
                    <a:bodyPr/>
                    <a:lstStyle/>
                    <a:p>
                      <a:pPr marL="0" algn="l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000" dirty="0">
                          <a:effectLst/>
                          <a:latin typeface="Arial Nova Cond"/>
                        </a:rPr>
                        <a:t>Supplementary Table 4</a:t>
                      </a: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AU" sz="1700" dirty="0">
                        <a:effectLst/>
                        <a:latin typeface="Arial Nova Cond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AU" sz="1700" dirty="0">
                        <a:effectLst/>
                        <a:latin typeface="Arial Nova Cond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AU" sz="1700" dirty="0">
                        <a:effectLst/>
                        <a:latin typeface="Arial Nova Cond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264535724"/>
                  </a:ext>
                </a:extLst>
              </a:tr>
              <a:tr h="509580"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kern="1200" dirty="0">
                          <a:effectLst/>
                          <a:latin typeface="Arial Nova Cond"/>
                        </a:rPr>
                        <a:t>RBD</a:t>
                      </a:r>
                      <a:endParaRPr lang="en-AU" sz="1700" dirty="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i="1" kern="1200">
                          <a:effectLst/>
                          <a:latin typeface="Arial Nova Cond"/>
                        </a:rPr>
                        <a:t>K</a:t>
                      </a:r>
                      <a:r>
                        <a:rPr lang="en-AU" sz="1300" i="1" kern="1200" baseline="-25000">
                          <a:effectLst/>
                          <a:latin typeface="Arial Nova Cond"/>
                        </a:rPr>
                        <a:t>D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 (</a:t>
                      </a:r>
                      <a:r>
                        <a:rPr lang="en-AU" sz="1300" kern="1200" err="1">
                          <a:effectLst/>
                          <a:latin typeface="Arial Nova Cond"/>
                        </a:rPr>
                        <a:t>nM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)</a:t>
                      </a: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kern="1200">
                          <a:effectLst/>
                          <a:latin typeface="Arial Nova Cond"/>
                        </a:rPr>
                        <a:t>SD</a:t>
                      </a: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kern="1200" err="1">
                          <a:effectLst/>
                          <a:latin typeface="Arial Nova Cond"/>
                        </a:rPr>
                        <a:t>k</a:t>
                      </a:r>
                      <a:r>
                        <a:rPr lang="en-AU" sz="1300" kern="1200" baseline="-25000" err="1">
                          <a:effectLst/>
                          <a:latin typeface="Arial Nova Cond"/>
                        </a:rPr>
                        <a:t>on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 (µM</a:t>
                      </a:r>
                      <a:r>
                        <a:rPr lang="en-AU" sz="1300" kern="1200" baseline="30000">
                          <a:effectLst/>
                          <a:latin typeface="Arial Nova Cond"/>
                        </a:rPr>
                        <a:t>-1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s</a:t>
                      </a:r>
                      <a:r>
                        <a:rPr lang="en-AU" sz="1300" kern="1200" baseline="30000">
                          <a:effectLst/>
                          <a:latin typeface="Arial Nova Cond"/>
                        </a:rPr>
                        <a:t>-1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)</a:t>
                      </a: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kern="1200">
                          <a:effectLst/>
                          <a:latin typeface="Arial Nova Cond"/>
                        </a:rPr>
                        <a:t>SD</a:t>
                      </a: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kern="1200" err="1">
                          <a:effectLst/>
                          <a:latin typeface="Arial Nova Cond"/>
                        </a:rPr>
                        <a:t>k</a:t>
                      </a:r>
                      <a:r>
                        <a:rPr lang="en-AU" sz="1300" kern="1200" baseline="-25000" err="1">
                          <a:effectLst/>
                          <a:latin typeface="Arial Nova Cond"/>
                        </a:rPr>
                        <a:t>off</a:t>
                      </a:r>
                      <a:r>
                        <a:rPr lang="en-AU" sz="1300" kern="1200" baseline="-25000">
                          <a:effectLst/>
                          <a:latin typeface="Arial Nova Cond"/>
                        </a:rPr>
                        <a:t> 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(s</a:t>
                      </a:r>
                      <a:r>
                        <a:rPr lang="en-AU" sz="1300" kern="1200" baseline="30000">
                          <a:effectLst/>
                          <a:latin typeface="Arial Nova Cond"/>
                        </a:rPr>
                        <a:t>-1</a:t>
                      </a:r>
                      <a:r>
                        <a:rPr lang="en-AU" sz="1300" kern="1200">
                          <a:effectLst/>
                          <a:latin typeface="Arial Nova Cond"/>
                        </a:rPr>
                        <a:t>)</a:t>
                      </a: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kern="1200">
                          <a:effectLst/>
                          <a:latin typeface="Arial Nova Cond"/>
                        </a:rPr>
                        <a:t>SD</a:t>
                      </a:r>
                      <a:endParaRPr lang="en-AU" sz="1700">
                        <a:effectLst/>
                        <a:latin typeface="Arial Nova Cond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8452614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Ancestral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9.4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.62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8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9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825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16</a:t>
                      </a:r>
                    </a:p>
                  </a:txBody>
                  <a:tcPr marL="0" marR="0" marT="0" marB="0" anchor="ctr"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0471374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Alpha (N501Y) 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6.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4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3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2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1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0158114"/>
                  </a:ext>
                </a:extLst>
              </a:tr>
              <a:tr h="274389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Beta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4.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.2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427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8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8607234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Delta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1.5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63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2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6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480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01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3302806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Gamma</a:t>
                      </a:r>
                      <a:endParaRPr lang="en-US" sz="120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5.0</a:t>
                      </a:r>
                      <a:endParaRPr lang="en-US" sz="120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.64</a:t>
                      </a:r>
                      <a:endParaRPr lang="en-US" sz="120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2</a:t>
                      </a:r>
                      <a:endParaRPr lang="en-US" sz="120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1</a:t>
                      </a:r>
                      <a:endParaRPr lang="en-US" sz="120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325</a:t>
                      </a:r>
                      <a:endParaRPr lang="en-US" sz="1200" dirty="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lvl="0" algn="ctr" defTabSz="755934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None/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52</a:t>
                      </a:r>
                      <a:endParaRPr lang="en-US" sz="1200"/>
                    </a:p>
                  </a:txBody>
                  <a:tcPr marL="0" marR="0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0334648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Omicron BA2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1.0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3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39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2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427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19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9014657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K417N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34.2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5.8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3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05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22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2975627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K417T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11.5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2.0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1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795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7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7275086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G446S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46.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3.1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197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97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4326033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L452R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7.3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54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1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7010323"/>
                  </a:ext>
                </a:extLst>
              </a:tr>
              <a:tr h="26459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L452R E484Q (Kappa)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4.8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3.77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55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3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6420375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Y453F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9.67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4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1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3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125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2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258034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S477N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0.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1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4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3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4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2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2674004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T478K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38.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6.3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92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16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0054778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E484D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10.77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6.8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28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218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2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2385073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E484K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37.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.5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90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3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9654352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E484Q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46.3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7.6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1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2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834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5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5545789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S494P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7.95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2.62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5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2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68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16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6878756"/>
                  </a:ext>
                </a:extLst>
              </a:tr>
              <a:tr h="256410"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1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N501T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1.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1.10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29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1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318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73025" marR="73025" algn="ctr" defTabSz="755934" rtl="0" eaLnBrk="1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AU" sz="1300" b="0" kern="1200" dirty="0">
                          <a:solidFill>
                            <a:schemeClr val="tx1"/>
                          </a:solidFill>
                          <a:effectLst/>
                          <a:latin typeface="Arial Nova Cond"/>
                          <a:ea typeface="+mn-ea"/>
                          <a:cs typeface="+mn-cs"/>
                        </a:rPr>
                        <a:t>0.00023</a:t>
                      </a:r>
                    </a:p>
                  </a:txBody>
                  <a:tcPr marL="0" marR="0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186158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A817A24-58C5-A2A0-FA38-9174E1A92692}"/>
              </a:ext>
            </a:extLst>
          </p:cNvPr>
          <p:cNvSpPr txBox="1"/>
          <p:nvPr/>
        </p:nvSpPr>
        <p:spPr>
          <a:xfrm>
            <a:off x="133073" y="6802774"/>
            <a:ext cx="6591854" cy="72592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2953" tIns="41476" rIns="82953" bIns="41476" numCol="1" spcCol="0" rtlCol="0" fromWordArt="0" anchor="ctr" anchorCtr="0" forceAA="0" compatLnSpc="1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70" i="1" dirty="0">
                <a:latin typeface="Arial Nova Cond"/>
                <a:ea typeface="+mn-lt"/>
                <a:cs typeface="+mn-lt"/>
              </a:rPr>
              <a:t>K</a:t>
            </a:r>
            <a:r>
              <a:rPr lang="en-US" sz="1270" i="1" baseline="-25000" dirty="0">
                <a:latin typeface="Arial Nova Cond"/>
                <a:ea typeface="+mn-lt"/>
                <a:cs typeface="+mn-lt"/>
              </a:rPr>
              <a:t>D</a:t>
            </a:r>
            <a:r>
              <a:rPr lang="en-US" sz="1270" dirty="0">
                <a:latin typeface="Arial Nova Cond"/>
                <a:ea typeface="+mn-lt"/>
                <a:cs typeface="+mn-lt"/>
              </a:rPr>
              <a:t> = dissociation constant, </a:t>
            </a:r>
            <a:r>
              <a:rPr lang="en-US" sz="1270" dirty="0" err="1">
                <a:latin typeface="Arial Nova Cond"/>
                <a:ea typeface="+mn-lt"/>
                <a:cs typeface="+mn-lt"/>
              </a:rPr>
              <a:t>k</a:t>
            </a:r>
            <a:r>
              <a:rPr lang="en-US" sz="1270" baseline="-25000" dirty="0" err="1">
                <a:latin typeface="Arial Nova Cond"/>
                <a:ea typeface="+mn-lt"/>
                <a:cs typeface="+mn-lt"/>
              </a:rPr>
              <a:t>on</a:t>
            </a:r>
            <a:r>
              <a:rPr lang="en-US" sz="1270" dirty="0">
                <a:latin typeface="Arial Nova Cond"/>
                <a:ea typeface="+mn-lt"/>
                <a:cs typeface="+mn-lt"/>
              </a:rPr>
              <a:t> = association rate constant, </a:t>
            </a:r>
            <a:r>
              <a:rPr lang="en-US" sz="1270" dirty="0" err="1">
                <a:latin typeface="Arial Nova Cond"/>
                <a:ea typeface="+mn-lt"/>
                <a:cs typeface="+mn-lt"/>
              </a:rPr>
              <a:t>k</a:t>
            </a:r>
            <a:r>
              <a:rPr lang="en-US" sz="1270" baseline="-25000" dirty="0" err="1">
                <a:latin typeface="Arial Nova Cond"/>
                <a:ea typeface="+mn-lt"/>
                <a:cs typeface="+mn-lt"/>
              </a:rPr>
              <a:t>off</a:t>
            </a:r>
            <a:r>
              <a:rPr lang="en-US" sz="1270" dirty="0">
                <a:latin typeface="Arial Nova Cond"/>
                <a:ea typeface="+mn-lt"/>
                <a:cs typeface="+mn-lt"/>
              </a:rPr>
              <a:t> = dissociation rate constant  </a:t>
            </a:r>
            <a:endParaRPr lang="en-US" sz="1633" dirty="0">
              <a:cs typeface="Calibri"/>
            </a:endParaRPr>
          </a:p>
          <a:p>
            <a:r>
              <a:rPr lang="en-AU" sz="1270" dirty="0"/>
              <a:t>Measured via BLI, calculated from 2 independent experiments</a:t>
            </a:r>
          </a:p>
          <a:p>
            <a:pPr algn="l"/>
            <a:endParaRPr lang="en-US" sz="1633" dirty="0">
              <a:cs typeface="Calibri"/>
            </a:endParaRPr>
          </a:p>
        </p:txBody>
      </p:sp>
      <p:sp>
        <p:nvSpPr>
          <p:cNvPr id="9" name="Text Box 27">
            <a:extLst>
              <a:ext uri="{FF2B5EF4-FFF2-40B4-BE49-F238E27FC236}">
                <a16:creationId xmlns:a16="http://schemas.microsoft.com/office/drawing/2014/main" id="{D3B6BD27-3BA7-FE29-55C3-61D969003392}"/>
              </a:ext>
            </a:extLst>
          </p:cNvPr>
          <p:cNvSpPr txBox="1"/>
          <p:nvPr/>
        </p:nvSpPr>
        <p:spPr>
          <a:xfrm>
            <a:off x="159084" y="889129"/>
            <a:ext cx="5943649" cy="243098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endParaRPr lang="en-AU" sz="1089" b="1">
              <a:highlight>
                <a:srgbClr val="FFFF00"/>
              </a:highlight>
              <a:latin typeface="Arial Nova Cond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89477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AB2F1DE-231E-5EBF-D9FF-1F0EDE9DF0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5068549"/>
              </p:ext>
            </p:extLst>
          </p:nvPr>
        </p:nvGraphicFramePr>
        <p:xfrm>
          <a:off x="457176" y="1634892"/>
          <a:ext cx="6217535" cy="452735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74433">
                  <a:extLst>
                    <a:ext uri="{9D8B030D-6E8A-4147-A177-3AD203B41FA5}">
                      <a16:colId xmlns:a16="http://schemas.microsoft.com/office/drawing/2014/main" val="525988957"/>
                    </a:ext>
                  </a:extLst>
                </a:gridCol>
                <a:gridCol w="916512">
                  <a:extLst>
                    <a:ext uri="{9D8B030D-6E8A-4147-A177-3AD203B41FA5}">
                      <a16:colId xmlns:a16="http://schemas.microsoft.com/office/drawing/2014/main" val="3539217465"/>
                    </a:ext>
                  </a:extLst>
                </a:gridCol>
                <a:gridCol w="552623">
                  <a:extLst>
                    <a:ext uri="{9D8B030D-6E8A-4147-A177-3AD203B41FA5}">
                      <a16:colId xmlns:a16="http://schemas.microsoft.com/office/drawing/2014/main" val="2905353570"/>
                    </a:ext>
                  </a:extLst>
                </a:gridCol>
                <a:gridCol w="664516">
                  <a:extLst>
                    <a:ext uri="{9D8B030D-6E8A-4147-A177-3AD203B41FA5}">
                      <a16:colId xmlns:a16="http://schemas.microsoft.com/office/drawing/2014/main" val="934257036"/>
                    </a:ext>
                  </a:extLst>
                </a:gridCol>
                <a:gridCol w="476072">
                  <a:extLst>
                    <a:ext uri="{9D8B030D-6E8A-4147-A177-3AD203B41FA5}">
                      <a16:colId xmlns:a16="http://schemas.microsoft.com/office/drawing/2014/main" val="1849407529"/>
                    </a:ext>
                  </a:extLst>
                </a:gridCol>
                <a:gridCol w="595088">
                  <a:extLst>
                    <a:ext uri="{9D8B030D-6E8A-4147-A177-3AD203B41FA5}">
                      <a16:colId xmlns:a16="http://schemas.microsoft.com/office/drawing/2014/main" val="3128466597"/>
                    </a:ext>
                  </a:extLst>
                </a:gridCol>
                <a:gridCol w="773617">
                  <a:extLst>
                    <a:ext uri="{9D8B030D-6E8A-4147-A177-3AD203B41FA5}">
                      <a16:colId xmlns:a16="http://schemas.microsoft.com/office/drawing/2014/main" val="1516962322"/>
                    </a:ext>
                  </a:extLst>
                </a:gridCol>
                <a:gridCol w="446315">
                  <a:extLst>
                    <a:ext uri="{9D8B030D-6E8A-4147-A177-3AD203B41FA5}">
                      <a16:colId xmlns:a16="http://schemas.microsoft.com/office/drawing/2014/main" val="3196588278"/>
                    </a:ext>
                  </a:extLst>
                </a:gridCol>
                <a:gridCol w="575253">
                  <a:extLst>
                    <a:ext uri="{9D8B030D-6E8A-4147-A177-3AD203B41FA5}">
                      <a16:colId xmlns:a16="http://schemas.microsoft.com/office/drawing/2014/main" val="2870407428"/>
                    </a:ext>
                  </a:extLst>
                </a:gridCol>
                <a:gridCol w="543106">
                  <a:extLst>
                    <a:ext uri="{9D8B030D-6E8A-4147-A177-3AD203B41FA5}">
                      <a16:colId xmlns:a16="http://schemas.microsoft.com/office/drawing/2014/main" val="3100008347"/>
                    </a:ext>
                  </a:extLst>
                </a:gridCol>
              </a:tblGrid>
              <a:tr h="73768">
                <a:tc gridSpan="10">
                  <a:txBody>
                    <a:bodyPr/>
                    <a:lstStyle/>
                    <a:p>
                      <a:pPr algn="l"/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upplementary Table 5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7392897"/>
                  </a:ext>
                </a:extLst>
              </a:tr>
              <a:tr h="649524">
                <a:tc>
                  <a:txBody>
                    <a:bodyPr/>
                    <a:lstStyle/>
                    <a:p>
                      <a:pPr indent="22225"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  <a:p>
                      <a:pPr indent="22225" algn="ctr"/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RBD</a:t>
                      </a:r>
                    </a:p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hACE-2 variant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Conc. (</a:t>
                      </a:r>
                      <a:r>
                        <a:rPr lang="en-US" sz="1000" err="1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nM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)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</a:t>
                      </a:r>
                      <a:r>
                        <a:rPr lang="en-US" sz="1000" baseline="-25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D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 (</a:t>
                      </a:r>
                      <a:r>
                        <a:rPr lang="en-US" sz="1000" err="1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nM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)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D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Ratio to WT ACE2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err="1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</a:t>
                      </a:r>
                      <a:r>
                        <a:rPr lang="en-US" sz="1000" baseline="-25000" err="1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on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 (µM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-1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-1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)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D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err="1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</a:t>
                      </a:r>
                      <a:r>
                        <a:rPr lang="en-US" sz="1000" baseline="-25000" err="1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off</a:t>
                      </a:r>
                      <a:r>
                        <a:rPr lang="en-US" sz="1000" baseline="-25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 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(s</a:t>
                      </a:r>
                      <a:r>
                        <a:rPr lang="en-US" sz="1000" baseline="30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-1</a:t>
                      </a: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)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D</a:t>
                      </a:r>
                    </a:p>
                  </a:txBody>
                  <a:tcPr marL="62215" marR="62215" marT="0" marB="0" anchor="ctr">
                    <a:lnL w="0">
                      <a:noFill/>
                    </a:lnL>
                    <a:lnR w="0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8424736"/>
                  </a:ext>
                </a:extLst>
              </a:tr>
              <a:tr h="186645">
                <a:tc rowSpan="4">
                  <a:txBody>
                    <a:bodyPr/>
                    <a:lstStyle/>
                    <a:p>
                      <a:pPr marL="71755" marR="71755" algn="ctr">
                        <a:lnSpc>
                          <a:spcPct val="200000"/>
                        </a:lnSpc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Ancestral</a:t>
                      </a:r>
                    </a:p>
                    <a:p>
                      <a:pPr marL="71755" marR="71755"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vert="vert27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WT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9.4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.6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8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9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83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16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5265213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E35K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36.63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3.6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80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013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7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1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85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959862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26R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0.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3.4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1.47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074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25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61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54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123729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19P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4.38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.2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2.04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844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2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41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38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669893"/>
                  </a:ext>
                </a:extLst>
              </a:tr>
              <a:tr h="186645">
                <a:tc rowSpan="4">
                  <a:txBody>
                    <a:bodyPr/>
                    <a:lstStyle/>
                    <a:p>
                      <a:pPr marL="71755" marR="71755"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Alpha (N501Y)</a:t>
                      </a:r>
                    </a:p>
                    <a:p>
                      <a:pPr marL="71755" marR="71755"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vert="vert27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WT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6.4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4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30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3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2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1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290185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E35K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9.2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3.7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6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00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4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0027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9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1269322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26R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4.97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.8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.2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404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3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0017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55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263285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19P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.9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9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.1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32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8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0010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3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05732"/>
                  </a:ext>
                </a:extLst>
              </a:tr>
              <a:tr h="186645">
                <a:tc rowSpan="4">
                  <a:txBody>
                    <a:bodyPr/>
                    <a:lstStyle/>
                    <a:p>
                      <a:pPr marL="71755" marR="71755"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Beta</a:t>
                      </a:r>
                    </a:p>
                    <a:p>
                      <a:pPr marL="71755" marR="71755"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vert="vert27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WT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4.6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.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90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3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4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8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1521379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E35K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72.5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9.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20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83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7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20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71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1093789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26R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7.4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7.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84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25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93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5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9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598001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19P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.5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1.39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627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26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2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05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3087250"/>
                  </a:ext>
                </a:extLst>
              </a:tr>
              <a:tr h="179178">
                <a:tc rowSpan="4">
                  <a:txBody>
                    <a:bodyPr/>
                    <a:lstStyle/>
                    <a:p>
                      <a:pPr marL="71755" marR="71755"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Delta</a:t>
                      </a:r>
                    </a:p>
                    <a:p>
                      <a:pPr marL="71755" marR="71755"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vert="vert27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WT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1.5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20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6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4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0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0046043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E35K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43.34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2.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50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06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49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3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15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250447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26R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3.47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2.5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1.60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295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42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44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25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2930901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19P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8.5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.4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2.51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215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26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27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2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3406583"/>
                  </a:ext>
                </a:extLst>
              </a:tr>
              <a:tr h="186645">
                <a:tc rowSpan="4">
                  <a:txBody>
                    <a:bodyPr/>
                    <a:lstStyle/>
                    <a:p>
                      <a:pPr marL="71755" marR="71755"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Omicron BA.2 </a:t>
                      </a:r>
                    </a:p>
                    <a:p>
                      <a:pPr marL="71755" marR="71755"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 vert="vert27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WT </a:t>
                      </a:r>
                    </a:p>
                  </a:txBody>
                  <a:tcPr marL="62215" marR="622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1.00</a:t>
                      </a: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</a:t>
                      </a: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solidFill>
                          <a:schemeClr val="tx1"/>
                        </a:solidFill>
                        <a:effectLst/>
                        <a:latin typeface="Arial Nova Cond"/>
                      </a:endParaRP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3900</a:t>
                      </a: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20 </a:t>
                      </a: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43</a:t>
                      </a: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019</a:t>
                      </a:r>
                    </a:p>
                  </a:txBody>
                  <a:tcPr marL="62215" marR="6221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0493893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E35K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8.5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5.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0.59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2817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18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5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13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2756264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K26R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5.1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.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2.12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6210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75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33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139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2134038"/>
                  </a:ext>
                </a:extLst>
              </a:tr>
              <a:tr h="1866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S19P 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00</a:t>
                      </a:r>
                    </a:p>
                  </a:txBody>
                  <a:tcPr marL="62215" marR="62215" marT="0" marB="0" anchor="ctr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4.97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1.2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 2.21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5631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77 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28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 Nova Cond"/>
                        </a:rPr>
                        <a:t>0.00106</a:t>
                      </a:r>
                    </a:p>
                  </a:txBody>
                  <a:tcPr marL="62215" marR="62215" marT="0" marB="0"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378833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D7AFF5D-A287-DAA5-B118-6D7069AFE6DC}"/>
              </a:ext>
            </a:extLst>
          </p:cNvPr>
          <p:cNvSpPr txBox="1"/>
          <p:nvPr/>
        </p:nvSpPr>
        <p:spPr>
          <a:xfrm>
            <a:off x="457175" y="6133233"/>
            <a:ext cx="5626023" cy="287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270" dirty="0"/>
              <a:t>Measured via BLI, calculated from 2 independent experiments</a:t>
            </a:r>
          </a:p>
        </p:txBody>
      </p:sp>
    </p:spTree>
    <p:extLst>
      <p:ext uri="{BB962C8B-B14F-4D97-AF65-F5344CB8AC3E}">
        <p14:creationId xmlns:p14="http://schemas.microsoft.com/office/powerpoint/2010/main" val="25582504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803E2F2-993F-0171-D450-8CE04EE547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5459390"/>
              </p:ext>
            </p:extLst>
          </p:nvPr>
        </p:nvGraphicFramePr>
        <p:xfrm>
          <a:off x="341893" y="1028157"/>
          <a:ext cx="5916141" cy="223933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88885">
                  <a:extLst>
                    <a:ext uri="{9D8B030D-6E8A-4147-A177-3AD203B41FA5}">
                      <a16:colId xmlns:a16="http://schemas.microsoft.com/office/drawing/2014/main" val="1586779386"/>
                    </a:ext>
                  </a:extLst>
                </a:gridCol>
                <a:gridCol w="637309">
                  <a:extLst>
                    <a:ext uri="{9D8B030D-6E8A-4147-A177-3AD203B41FA5}">
                      <a16:colId xmlns:a16="http://schemas.microsoft.com/office/drawing/2014/main" val="3660126832"/>
                    </a:ext>
                  </a:extLst>
                </a:gridCol>
                <a:gridCol w="645853">
                  <a:extLst>
                    <a:ext uri="{9D8B030D-6E8A-4147-A177-3AD203B41FA5}">
                      <a16:colId xmlns:a16="http://schemas.microsoft.com/office/drawing/2014/main" val="1179950726"/>
                    </a:ext>
                  </a:extLst>
                </a:gridCol>
                <a:gridCol w="657349">
                  <a:extLst>
                    <a:ext uri="{9D8B030D-6E8A-4147-A177-3AD203B41FA5}">
                      <a16:colId xmlns:a16="http://schemas.microsoft.com/office/drawing/2014/main" val="4275061708"/>
                    </a:ext>
                  </a:extLst>
                </a:gridCol>
                <a:gridCol w="657349">
                  <a:extLst>
                    <a:ext uri="{9D8B030D-6E8A-4147-A177-3AD203B41FA5}">
                      <a16:colId xmlns:a16="http://schemas.microsoft.com/office/drawing/2014/main" val="3356288061"/>
                    </a:ext>
                  </a:extLst>
                </a:gridCol>
                <a:gridCol w="657349">
                  <a:extLst>
                    <a:ext uri="{9D8B030D-6E8A-4147-A177-3AD203B41FA5}">
                      <a16:colId xmlns:a16="http://schemas.microsoft.com/office/drawing/2014/main" val="2101118203"/>
                    </a:ext>
                  </a:extLst>
                </a:gridCol>
                <a:gridCol w="657349">
                  <a:extLst>
                    <a:ext uri="{9D8B030D-6E8A-4147-A177-3AD203B41FA5}">
                      <a16:colId xmlns:a16="http://schemas.microsoft.com/office/drawing/2014/main" val="271072351"/>
                    </a:ext>
                  </a:extLst>
                </a:gridCol>
                <a:gridCol w="657349">
                  <a:extLst>
                    <a:ext uri="{9D8B030D-6E8A-4147-A177-3AD203B41FA5}">
                      <a16:colId xmlns:a16="http://schemas.microsoft.com/office/drawing/2014/main" val="3600563601"/>
                    </a:ext>
                  </a:extLst>
                </a:gridCol>
                <a:gridCol w="657349">
                  <a:extLst>
                    <a:ext uri="{9D8B030D-6E8A-4147-A177-3AD203B41FA5}">
                      <a16:colId xmlns:a16="http://schemas.microsoft.com/office/drawing/2014/main" val="282104321"/>
                    </a:ext>
                  </a:extLst>
                </a:gridCol>
              </a:tblGrid>
              <a:tr h="141167">
                <a:tc gridSpan="9">
                  <a:txBody>
                    <a:bodyPr/>
                    <a:lstStyle/>
                    <a:p>
                      <a:pPr algn="l" rtl="0" fontAlgn="b"/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Nova" panose="020B0504020202020204" pitchFamily="34" charset="0"/>
                        </a:rPr>
                        <a:t>Supplementary Table 6</a:t>
                      </a: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60976772"/>
                  </a:ext>
                </a:extLst>
              </a:tr>
              <a:tr h="616897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 dirty="0">
                          <a:effectLst/>
                          <a:latin typeface="Arial Nova" panose="020B0504020202020204" pitchFamily="34" charset="0"/>
                        </a:rPr>
                        <a:t>Population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Ashkenazi Jewish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European (non-Finnish)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Other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Latino/Admixed American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South Asian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African/African American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European (Finnish)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u="none" strike="noStrike">
                          <a:effectLst/>
                          <a:latin typeface="Arial Nova" panose="020B0504020202020204" pitchFamily="34" charset="0"/>
                        </a:rPr>
                        <a:t>East Asian </a:t>
                      </a:r>
                      <a:endParaRPr lang="en-AU" sz="1000" b="1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64083874"/>
                  </a:ext>
                </a:extLst>
              </a:tr>
              <a:tr h="53288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i="1" u="none" strike="noStrike" dirty="0">
                          <a:effectLst/>
                          <a:latin typeface="Arial Nova" panose="020B0504020202020204" pitchFamily="34" charset="0"/>
                        </a:rPr>
                        <a:t>K26R Allele Frequency </a:t>
                      </a:r>
                      <a:endParaRPr lang="en-AU" sz="1000" b="1" i="1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  <a:latin typeface="Arial Nova" panose="020B0504020202020204" pitchFamily="34" charset="0"/>
                        </a:rPr>
                        <a:t>0.01188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586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337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324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  <a:latin typeface="Arial Nova" panose="020B0504020202020204" pitchFamily="34" charset="0"/>
                        </a:rPr>
                        <a:t>0.001313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094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048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 Nova" panose="020B0504020202020204" pitchFamily="34" charset="0"/>
                        </a:rPr>
                        <a:t>0.000067</a:t>
                      </a: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82388140"/>
                  </a:ext>
                </a:extLst>
              </a:tr>
              <a:tr h="448887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i="1" u="none" strike="noStrike">
                          <a:effectLst/>
                          <a:latin typeface="Arial Nova" panose="020B0504020202020204" pitchFamily="34" charset="0"/>
                        </a:rPr>
                        <a:t>S19P Allele Frequency </a:t>
                      </a:r>
                      <a:endParaRPr lang="en-AU" sz="1000" b="1" i="1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0188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.00332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28687319"/>
                  </a:ext>
                </a:extLst>
              </a:tr>
              <a:tr h="38865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1" i="1" u="none" strike="noStrike" dirty="0">
                          <a:effectLst/>
                          <a:latin typeface="Arial Nova" panose="020B0504020202020204" pitchFamily="34" charset="0"/>
                        </a:rPr>
                        <a:t>E35K Allele Frequency </a:t>
                      </a:r>
                      <a:endParaRPr lang="en-AU" sz="1000" b="1" i="1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Arial Nova" panose="020B0504020202020204" pitchFamily="34" charset="0"/>
                        </a:rPr>
                        <a:t>0.000012</a:t>
                      </a: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  <a:latin typeface="Arial Nova" panose="020B0504020202020204" pitchFamily="34" charset="0"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  <a:latin typeface="Arial Nova" panose="020B0504020202020204" pitchFamily="34" charset="0"/>
                        </a:rPr>
                        <a:t>0.00014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 Nova" panose="020B0504020202020204" pitchFamily="34" charset="0"/>
                      </a:endParaRPr>
                    </a:p>
                  </a:txBody>
                  <a:tcPr marL="7585" marR="7585" marT="75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5487298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E614CB6-2849-DE13-C167-8412564FAB4E}"/>
              </a:ext>
            </a:extLst>
          </p:cNvPr>
          <p:cNvSpPr txBox="1"/>
          <p:nvPr/>
        </p:nvSpPr>
        <p:spPr>
          <a:xfrm>
            <a:off x="267315" y="3267490"/>
            <a:ext cx="5990719" cy="427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089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olymorphism data collated from Genome Aggregation Database (</a:t>
            </a:r>
            <a:r>
              <a:rPr lang="en-AU" sz="1089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nomAD</a:t>
            </a:r>
            <a:r>
              <a:rPr lang="en-AU" sz="1089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2.1.1; https://</a:t>
            </a:r>
            <a:r>
              <a:rPr lang="en-AU" sz="1089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nomad.broadinstitute.org</a:t>
            </a:r>
            <a:r>
              <a:rPr lang="en-AU" sz="1089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AU" sz="1089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8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9617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A3639B17-702C-AF40-A78F-927CE4EAF884}"/>
              </a:ext>
            </a:extLst>
          </p:cNvPr>
          <p:cNvGraphicFramePr>
            <a:graphicFrameLocks/>
          </p:cNvGraphicFramePr>
          <p:nvPr/>
        </p:nvGraphicFramePr>
        <p:xfrm>
          <a:off x="3658159" y="187861"/>
          <a:ext cx="3282909" cy="2186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BB3707EE-DA1D-044D-AAB7-BD4D49DFB090}"/>
              </a:ext>
            </a:extLst>
          </p:cNvPr>
          <p:cNvGraphicFramePr>
            <a:graphicFrameLocks/>
          </p:cNvGraphicFramePr>
          <p:nvPr/>
        </p:nvGraphicFramePr>
        <p:xfrm>
          <a:off x="429964" y="2303315"/>
          <a:ext cx="3307154" cy="21646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F6224CF6-0BC2-AA47-BB49-B6A7DD4F3B66}"/>
              </a:ext>
            </a:extLst>
          </p:cNvPr>
          <p:cNvGraphicFramePr>
            <a:graphicFrameLocks/>
          </p:cNvGraphicFramePr>
          <p:nvPr/>
        </p:nvGraphicFramePr>
        <p:xfrm>
          <a:off x="3604388" y="2331276"/>
          <a:ext cx="3307154" cy="21646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1040F39C-D5D1-0C40-BB83-F51C99992F5F}"/>
              </a:ext>
            </a:extLst>
          </p:cNvPr>
          <p:cNvSpPr txBox="1"/>
          <p:nvPr/>
        </p:nvSpPr>
        <p:spPr>
          <a:xfrm>
            <a:off x="227794" y="434262"/>
            <a:ext cx="301686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 Box 14">
            <a:extLst>
              <a:ext uri="{FF2B5EF4-FFF2-40B4-BE49-F238E27FC236}">
                <a16:creationId xmlns:a16="http://schemas.microsoft.com/office/drawing/2014/main" id="{1963EE7B-AC8B-5A44-A24E-9B27A8E315F5}"/>
              </a:ext>
            </a:extLst>
          </p:cNvPr>
          <p:cNvSpPr txBox="1"/>
          <p:nvPr/>
        </p:nvSpPr>
        <p:spPr>
          <a:xfrm>
            <a:off x="227794" y="7389111"/>
            <a:ext cx="6144941" cy="2413599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AU" sz="1089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endParaRPr lang="en-AU" sz="108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B1E230B-7A31-7B41-AA92-0A013C099CA3}"/>
              </a:ext>
            </a:extLst>
          </p:cNvPr>
          <p:cNvSpPr txBox="1"/>
          <p:nvPr/>
        </p:nvSpPr>
        <p:spPr>
          <a:xfrm>
            <a:off x="224450" y="4121407"/>
            <a:ext cx="276592" cy="287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70" b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1C3F5A2-62B9-5449-8316-8058D8A0E069}"/>
              </a:ext>
            </a:extLst>
          </p:cNvPr>
          <p:cNvSpPr txBox="1"/>
          <p:nvPr/>
        </p:nvSpPr>
        <p:spPr>
          <a:xfrm>
            <a:off x="3718421" y="4109742"/>
            <a:ext cx="285318" cy="287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70" b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FEBD500-EFB4-0A4F-8999-45BE522B8C0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09816" y="4324857"/>
            <a:ext cx="3958216" cy="296866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90AD5F1-7BA8-AC40-A883-9F6F2FD263A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9898" y="6471743"/>
            <a:ext cx="1375242" cy="45841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F847FD3-6B6D-4D3F-DA2A-4EF86874BAD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18421" y="4453046"/>
            <a:ext cx="2978759" cy="287068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8D900EE-B8F3-3240-B4EA-3B27DFA5CF6B}"/>
              </a:ext>
            </a:extLst>
          </p:cNvPr>
          <p:cNvSpPr txBox="1"/>
          <p:nvPr/>
        </p:nvSpPr>
        <p:spPr>
          <a:xfrm>
            <a:off x="227794" y="2301971"/>
            <a:ext cx="301686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A629D3D-74AE-8B4F-8AF1-DA25451E8F81}"/>
              </a:ext>
            </a:extLst>
          </p:cNvPr>
          <p:cNvSpPr txBox="1"/>
          <p:nvPr/>
        </p:nvSpPr>
        <p:spPr>
          <a:xfrm>
            <a:off x="3656454" y="2300218"/>
            <a:ext cx="301686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0" b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CFBB7E-203E-B349-8B42-2C92842359A3}"/>
              </a:ext>
            </a:extLst>
          </p:cNvPr>
          <p:cNvSpPr txBox="1"/>
          <p:nvPr/>
        </p:nvSpPr>
        <p:spPr>
          <a:xfrm>
            <a:off x="3665179" y="354921"/>
            <a:ext cx="293670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97626CD8-C650-1E4E-94DA-198F2600EE4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6997" y="218074"/>
          <a:ext cx="3309467" cy="21646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41510167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72056A1-A544-6C6D-F219-BA13EDC27B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49" y="713726"/>
            <a:ext cx="6893009" cy="499202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2A96ACB-F8D8-E840-A508-325AC651FC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39261" y="228699"/>
            <a:ext cx="1396732" cy="458414"/>
          </a:xfrm>
          <a:prstGeom prst="rect">
            <a:avLst/>
          </a:prstGeom>
        </p:spPr>
      </p:pic>
      <p:sp>
        <p:nvSpPr>
          <p:cNvPr id="24" name="Text Box 14">
            <a:extLst>
              <a:ext uri="{FF2B5EF4-FFF2-40B4-BE49-F238E27FC236}">
                <a16:creationId xmlns:a16="http://schemas.microsoft.com/office/drawing/2014/main" id="{4A6BA502-9FE9-F644-BFE3-4F6A01F61AC3}"/>
              </a:ext>
            </a:extLst>
          </p:cNvPr>
          <p:cNvSpPr txBox="1"/>
          <p:nvPr/>
        </p:nvSpPr>
        <p:spPr>
          <a:xfrm>
            <a:off x="102603" y="9592461"/>
            <a:ext cx="6065294" cy="313539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AU" sz="1089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endParaRPr lang="en-AU" sz="108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623BE5D-444B-0A3A-18F4-F458BF6AEB00}"/>
              </a:ext>
            </a:extLst>
          </p:cNvPr>
          <p:cNvSpPr txBox="1"/>
          <p:nvPr/>
        </p:nvSpPr>
        <p:spPr>
          <a:xfrm>
            <a:off x="1725133" y="5705748"/>
            <a:ext cx="251992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J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0D8155-9103-2B69-73A2-980C6469CE8B}"/>
              </a:ext>
            </a:extLst>
          </p:cNvPr>
          <p:cNvSpPr txBox="1"/>
          <p:nvPr/>
        </p:nvSpPr>
        <p:spPr>
          <a:xfrm>
            <a:off x="4493272" y="3904868"/>
            <a:ext cx="237566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A421F4-2CD8-934B-872E-781AEA0296A6}"/>
              </a:ext>
            </a:extLst>
          </p:cNvPr>
          <p:cNvSpPr txBox="1"/>
          <p:nvPr/>
        </p:nvSpPr>
        <p:spPr>
          <a:xfrm>
            <a:off x="2297956" y="3904868"/>
            <a:ext cx="314510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B15C02F-7C1D-5978-FBD8-70DF59C77561}"/>
              </a:ext>
            </a:extLst>
          </p:cNvPr>
          <p:cNvSpPr txBox="1"/>
          <p:nvPr/>
        </p:nvSpPr>
        <p:spPr>
          <a:xfrm>
            <a:off x="102603" y="3904868"/>
            <a:ext cx="316112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8A0C6D-6F7E-32A6-6C7A-D73525A534F9}"/>
              </a:ext>
            </a:extLst>
          </p:cNvPr>
          <p:cNvSpPr txBox="1"/>
          <p:nvPr/>
        </p:nvSpPr>
        <p:spPr>
          <a:xfrm>
            <a:off x="4493272" y="2298128"/>
            <a:ext cx="280846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F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0DCEEB-F11F-070A-2BD3-B6A1D4526044}"/>
              </a:ext>
            </a:extLst>
          </p:cNvPr>
          <p:cNvSpPr txBox="1"/>
          <p:nvPr/>
        </p:nvSpPr>
        <p:spPr>
          <a:xfrm>
            <a:off x="2297957" y="2298128"/>
            <a:ext cx="287258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BAD7201-355A-2B1C-8696-04BDB6CBD279}"/>
              </a:ext>
            </a:extLst>
          </p:cNvPr>
          <p:cNvSpPr txBox="1"/>
          <p:nvPr/>
        </p:nvSpPr>
        <p:spPr>
          <a:xfrm>
            <a:off x="102603" y="2298128"/>
            <a:ext cx="312906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FBABCB-F49C-E924-6127-A2EF557B2C41}"/>
              </a:ext>
            </a:extLst>
          </p:cNvPr>
          <p:cNvSpPr txBox="1"/>
          <p:nvPr/>
        </p:nvSpPr>
        <p:spPr>
          <a:xfrm>
            <a:off x="4494480" y="691387"/>
            <a:ext cx="296876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5587C50-A2F5-6D6F-BD18-16AEB4C00A19}"/>
              </a:ext>
            </a:extLst>
          </p:cNvPr>
          <p:cNvSpPr txBox="1"/>
          <p:nvPr/>
        </p:nvSpPr>
        <p:spPr>
          <a:xfrm>
            <a:off x="2299165" y="691387"/>
            <a:ext cx="298480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2C100FA-DDD7-064E-F67B-D296BDE2BDDF}"/>
              </a:ext>
            </a:extLst>
          </p:cNvPr>
          <p:cNvSpPr txBox="1"/>
          <p:nvPr/>
        </p:nvSpPr>
        <p:spPr>
          <a:xfrm>
            <a:off x="103811" y="691387"/>
            <a:ext cx="306494" cy="3436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33" dirty="0"/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6A15C7E-54E5-036F-F10B-9D28E876BE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61751" y="5872327"/>
            <a:ext cx="4077510" cy="3522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3160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14">
            <a:extLst>
              <a:ext uri="{FF2B5EF4-FFF2-40B4-BE49-F238E27FC236}">
                <a16:creationId xmlns:a16="http://schemas.microsoft.com/office/drawing/2014/main" id="{05D4A551-30C8-4EF4-A7F3-54C61321E884}"/>
              </a:ext>
            </a:extLst>
          </p:cNvPr>
          <p:cNvSpPr txBox="1"/>
          <p:nvPr/>
        </p:nvSpPr>
        <p:spPr>
          <a:xfrm>
            <a:off x="129779" y="5647619"/>
            <a:ext cx="6065294" cy="153289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AU" sz="1089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</a:t>
            </a:r>
            <a:endParaRPr lang="en-AU" sz="108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3" descr="Diagram&#10;&#10;Description automatically generated">
            <a:extLst>
              <a:ext uri="{FF2B5EF4-FFF2-40B4-BE49-F238E27FC236}">
                <a16:creationId xmlns:a16="http://schemas.microsoft.com/office/drawing/2014/main" id="{C30BAF81-2BF1-9D47-D2EC-FEA8F42E80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78" y="479670"/>
            <a:ext cx="6651646" cy="516794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088A4ED-844B-7FF5-0DED-06F701E8CB71}"/>
              </a:ext>
            </a:extLst>
          </p:cNvPr>
          <p:cNvSpPr txBox="1"/>
          <p:nvPr/>
        </p:nvSpPr>
        <p:spPr>
          <a:xfrm>
            <a:off x="3455601" y="553133"/>
            <a:ext cx="271228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9186593-9AA7-4EF1-C556-8943CE34F4EE}"/>
              </a:ext>
            </a:extLst>
          </p:cNvPr>
          <p:cNvSpPr txBox="1"/>
          <p:nvPr/>
        </p:nvSpPr>
        <p:spPr>
          <a:xfrm>
            <a:off x="1873341" y="553133"/>
            <a:ext cx="272832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8E1753-770B-5573-FE56-7C750E6CFC95}"/>
              </a:ext>
            </a:extLst>
          </p:cNvPr>
          <p:cNvSpPr txBox="1"/>
          <p:nvPr/>
        </p:nvSpPr>
        <p:spPr>
          <a:xfrm>
            <a:off x="453513" y="553133"/>
            <a:ext cx="279244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8D60555-DA94-1DA3-CD45-C3A05C74E6EB}"/>
              </a:ext>
            </a:extLst>
          </p:cNvPr>
          <p:cNvSpPr txBox="1"/>
          <p:nvPr/>
        </p:nvSpPr>
        <p:spPr>
          <a:xfrm>
            <a:off x="4839012" y="553133"/>
            <a:ext cx="285656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8F9CC6-DB80-764D-B729-A5EBE1118C87}"/>
              </a:ext>
            </a:extLst>
          </p:cNvPr>
          <p:cNvSpPr txBox="1"/>
          <p:nvPr/>
        </p:nvSpPr>
        <p:spPr>
          <a:xfrm>
            <a:off x="2907083" y="2008872"/>
            <a:ext cx="287258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7F4511-3DB3-4A22-4456-A4BF0B3443A0}"/>
              </a:ext>
            </a:extLst>
          </p:cNvPr>
          <p:cNvSpPr txBox="1"/>
          <p:nvPr/>
        </p:nvSpPr>
        <p:spPr>
          <a:xfrm>
            <a:off x="1679723" y="2008872"/>
            <a:ext cx="260008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F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CA1D6D6-E4FF-CCCB-243E-FA4F311A4AD1}"/>
              </a:ext>
            </a:extLst>
          </p:cNvPr>
          <p:cNvSpPr txBox="1"/>
          <p:nvPr/>
        </p:nvSpPr>
        <p:spPr>
          <a:xfrm>
            <a:off x="319580" y="2008872"/>
            <a:ext cx="264816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B601E7-8AF6-9D0C-F58F-55ACAD6F1E15}"/>
              </a:ext>
            </a:extLst>
          </p:cNvPr>
          <p:cNvSpPr txBox="1"/>
          <p:nvPr/>
        </p:nvSpPr>
        <p:spPr>
          <a:xfrm>
            <a:off x="4265917" y="2008872"/>
            <a:ext cx="285656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48553EE-F18E-42BE-6FB2-2BD7837047CC}"/>
              </a:ext>
            </a:extLst>
          </p:cNvPr>
          <p:cNvSpPr txBox="1"/>
          <p:nvPr/>
        </p:nvSpPr>
        <p:spPr>
          <a:xfrm>
            <a:off x="5389010" y="2008871"/>
            <a:ext cx="226344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66E2EED-D3E0-202B-2B7A-AE1ADA2298CC}"/>
              </a:ext>
            </a:extLst>
          </p:cNvPr>
          <p:cNvSpPr txBox="1"/>
          <p:nvPr/>
        </p:nvSpPr>
        <p:spPr>
          <a:xfrm>
            <a:off x="3658917" y="3688640"/>
            <a:ext cx="253596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4E55520-763A-0A3D-04DF-648AA9F4557B}"/>
              </a:ext>
            </a:extLst>
          </p:cNvPr>
          <p:cNvSpPr txBox="1"/>
          <p:nvPr/>
        </p:nvSpPr>
        <p:spPr>
          <a:xfrm>
            <a:off x="2076657" y="3688640"/>
            <a:ext cx="269626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K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78014AF-4472-D5D6-E6F0-89100D5C4DAC}"/>
              </a:ext>
            </a:extLst>
          </p:cNvPr>
          <p:cNvSpPr txBox="1"/>
          <p:nvPr/>
        </p:nvSpPr>
        <p:spPr>
          <a:xfrm>
            <a:off x="656829" y="3688640"/>
            <a:ext cx="235962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J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71CD638-5369-9BB7-4928-03784615D2D4}"/>
              </a:ext>
            </a:extLst>
          </p:cNvPr>
          <p:cNvSpPr txBox="1"/>
          <p:nvPr/>
        </p:nvSpPr>
        <p:spPr>
          <a:xfrm>
            <a:off x="5042328" y="3688640"/>
            <a:ext cx="324128" cy="28777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270" dirty="0"/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24390933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4">
            <a:extLst>
              <a:ext uri="{FF2B5EF4-FFF2-40B4-BE49-F238E27FC236}">
                <a16:creationId xmlns:a16="http://schemas.microsoft.com/office/drawing/2014/main" id="{07E881FF-E4E8-E30C-F94C-082A857B6D9F}"/>
              </a:ext>
            </a:extLst>
          </p:cNvPr>
          <p:cNvSpPr txBox="1"/>
          <p:nvPr/>
        </p:nvSpPr>
        <p:spPr>
          <a:xfrm>
            <a:off x="0" y="9381419"/>
            <a:ext cx="6065294" cy="524581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AU" sz="1089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</a:t>
            </a:r>
            <a:endParaRPr lang="en-AU" sz="108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96AFABB-CFB0-DFA7-DB19-C4B1510326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3600" y="395558"/>
            <a:ext cx="5130800" cy="835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2386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4">
            <a:extLst>
              <a:ext uri="{FF2B5EF4-FFF2-40B4-BE49-F238E27FC236}">
                <a16:creationId xmlns:a16="http://schemas.microsoft.com/office/drawing/2014/main" id="{07E881FF-E4E8-E30C-F94C-082A857B6D9F}"/>
              </a:ext>
            </a:extLst>
          </p:cNvPr>
          <p:cNvSpPr txBox="1"/>
          <p:nvPr/>
        </p:nvSpPr>
        <p:spPr>
          <a:xfrm>
            <a:off x="228600" y="7113016"/>
            <a:ext cx="6065294" cy="524581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82953" tIns="41476" rIns="82953" bIns="4147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AU" sz="1089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6</a:t>
            </a:r>
            <a:endParaRPr lang="en-AU" sz="108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5E87CB5-46BD-A55E-52A0-C306A66A82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61416"/>
            <a:ext cx="6375400" cy="645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65641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2A858FD-62A6-0445-A9B3-6CE1057688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2219827"/>
              </p:ext>
            </p:extLst>
          </p:nvPr>
        </p:nvGraphicFramePr>
        <p:xfrm>
          <a:off x="808664" y="1079307"/>
          <a:ext cx="5240670" cy="127677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739809">
                  <a:extLst>
                    <a:ext uri="{9D8B030D-6E8A-4147-A177-3AD203B41FA5}">
                      <a16:colId xmlns:a16="http://schemas.microsoft.com/office/drawing/2014/main" val="2991926076"/>
                    </a:ext>
                  </a:extLst>
                </a:gridCol>
                <a:gridCol w="840981">
                  <a:extLst>
                    <a:ext uri="{9D8B030D-6E8A-4147-A177-3AD203B41FA5}">
                      <a16:colId xmlns:a16="http://schemas.microsoft.com/office/drawing/2014/main" val="2327656449"/>
                    </a:ext>
                  </a:extLst>
                </a:gridCol>
                <a:gridCol w="967796">
                  <a:extLst>
                    <a:ext uri="{9D8B030D-6E8A-4147-A177-3AD203B41FA5}">
                      <a16:colId xmlns:a16="http://schemas.microsoft.com/office/drawing/2014/main" val="1894555119"/>
                    </a:ext>
                  </a:extLst>
                </a:gridCol>
                <a:gridCol w="1643950">
                  <a:extLst>
                    <a:ext uri="{9D8B030D-6E8A-4147-A177-3AD203B41FA5}">
                      <a16:colId xmlns:a16="http://schemas.microsoft.com/office/drawing/2014/main" val="328565493"/>
                    </a:ext>
                  </a:extLst>
                </a:gridCol>
                <a:gridCol w="1048134">
                  <a:extLst>
                    <a:ext uri="{9D8B030D-6E8A-4147-A177-3AD203B41FA5}">
                      <a16:colId xmlns:a16="http://schemas.microsoft.com/office/drawing/2014/main" val="3962299075"/>
                    </a:ext>
                  </a:extLst>
                </a:gridCol>
              </a:tblGrid>
              <a:tr h="162141">
                <a:tc gridSpan="5">
                  <a:txBody>
                    <a:bodyPr/>
                    <a:lstStyle/>
                    <a:p>
                      <a:pPr algn="l"/>
                      <a:r>
                        <a:rPr lang="en-AU" sz="900" b="1" dirty="0">
                          <a:effectLst/>
                          <a:latin typeface="Arial Nova" panose="020B05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plementary Table 1</a:t>
                      </a: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900" b="1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900" b="1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900" b="1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b="1" dirty="0">
                        <a:latin typeface="Arial Nova" panose="020B0504020202020204" pitchFamily="34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94310019"/>
                  </a:ext>
                </a:extLst>
              </a:tr>
              <a:tr h="193559"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>
                          <a:effectLst/>
                          <a:latin typeface="Arial Nova" panose="020B0504020202020204" pitchFamily="34" charset="0"/>
                        </a:rPr>
                        <a:t>Bead Supplier</a:t>
                      </a:r>
                      <a:endParaRPr lang="en-AU" sz="900" b="1" dirty="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  <a:latin typeface="Arial Nova" panose="020B0504020202020204" pitchFamily="34" charset="0"/>
                        </a:rPr>
                        <a:t>Bead Region</a:t>
                      </a:r>
                      <a:endParaRPr lang="en-AU" sz="900" b="1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  <a:latin typeface="Arial Nova" panose="020B0504020202020204" pitchFamily="34" charset="0"/>
                        </a:rPr>
                        <a:t>Bead Catalogue Number</a:t>
                      </a:r>
                      <a:endParaRPr lang="en-AU" sz="900" b="1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  <a:latin typeface="Arial Nova" panose="020B0504020202020204" pitchFamily="34" charset="0"/>
                        </a:rPr>
                        <a:t>Antigen </a:t>
                      </a:r>
                      <a:endParaRPr lang="en-AU" sz="900" b="1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  <a:latin typeface="Arial Nova" panose="020B0504020202020204" pitchFamily="34" charset="0"/>
                        </a:rPr>
                        <a:t>Protein Coupled/1x10^7 beads</a:t>
                      </a:r>
                      <a:endParaRPr lang="en-US" sz="900" b="1">
                        <a:latin typeface="Arial Nova" panose="020B0504020202020204" pitchFamily="34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81536156"/>
                  </a:ext>
                </a:extLst>
              </a:tr>
              <a:tr h="142500"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Biorad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14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MC10014-01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Spike S1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dirty="0">
                          <a:effectLst/>
                          <a:latin typeface="Arial Nova" panose="020B0504020202020204" pitchFamily="34" charset="0"/>
                        </a:rPr>
                        <a:t>100ug</a:t>
                      </a:r>
                      <a:endParaRPr lang="en-AU" sz="900" dirty="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99771744"/>
                  </a:ext>
                </a:extLst>
              </a:tr>
              <a:tr h="100117"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Biorad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22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MC10022-01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Nucleoprotein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40ug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87143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Biorad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76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MC10076-01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Spike Trimer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100ug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3135223"/>
                  </a:ext>
                </a:extLst>
              </a:tr>
              <a:tr h="146170"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Biorad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74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MC10074-01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Influenza H1Cal2009 (control)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100ug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43804437"/>
                  </a:ext>
                </a:extLst>
              </a:tr>
              <a:tr h="140164"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Biorad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15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MC10015-01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>
                          <a:effectLst/>
                          <a:latin typeface="Arial Nova" panose="020B0504020202020204" pitchFamily="34" charset="0"/>
                        </a:rPr>
                        <a:t>SIVgp120 (control)</a:t>
                      </a:r>
                      <a:endParaRPr lang="en-AU" sz="9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dirty="0">
                          <a:effectLst/>
                          <a:latin typeface="Arial Nova" panose="020B0504020202020204" pitchFamily="34" charset="0"/>
                        </a:rPr>
                        <a:t>100ug</a:t>
                      </a:r>
                      <a:endParaRPr lang="en-AU" sz="900" dirty="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15" marR="6221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97966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09467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D9AA2200-B7FD-B84F-90A3-560A91CDE1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074367"/>
              </p:ext>
            </p:extLst>
          </p:nvPr>
        </p:nvGraphicFramePr>
        <p:xfrm>
          <a:off x="412370" y="551647"/>
          <a:ext cx="5927479" cy="8989056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513615">
                  <a:extLst>
                    <a:ext uri="{9D8B030D-6E8A-4147-A177-3AD203B41FA5}">
                      <a16:colId xmlns:a16="http://schemas.microsoft.com/office/drawing/2014/main" val="723709814"/>
                    </a:ext>
                  </a:extLst>
                </a:gridCol>
                <a:gridCol w="540157">
                  <a:extLst>
                    <a:ext uri="{9D8B030D-6E8A-4147-A177-3AD203B41FA5}">
                      <a16:colId xmlns:a16="http://schemas.microsoft.com/office/drawing/2014/main" val="3913095186"/>
                    </a:ext>
                  </a:extLst>
                </a:gridCol>
                <a:gridCol w="810236">
                  <a:extLst>
                    <a:ext uri="{9D8B030D-6E8A-4147-A177-3AD203B41FA5}">
                      <a16:colId xmlns:a16="http://schemas.microsoft.com/office/drawing/2014/main" val="3517658888"/>
                    </a:ext>
                  </a:extLst>
                </a:gridCol>
                <a:gridCol w="3086612">
                  <a:extLst>
                    <a:ext uri="{9D8B030D-6E8A-4147-A177-3AD203B41FA5}">
                      <a16:colId xmlns:a16="http://schemas.microsoft.com/office/drawing/2014/main" val="2193686310"/>
                    </a:ext>
                  </a:extLst>
                </a:gridCol>
                <a:gridCol w="976859">
                  <a:extLst>
                    <a:ext uri="{9D8B030D-6E8A-4147-A177-3AD203B41FA5}">
                      <a16:colId xmlns:a16="http://schemas.microsoft.com/office/drawing/2014/main" val="1761125114"/>
                    </a:ext>
                  </a:extLst>
                </a:gridCol>
              </a:tblGrid>
              <a:tr h="95775">
                <a:tc gridSpan="5">
                  <a:txBody>
                    <a:bodyPr/>
                    <a:lstStyle/>
                    <a:p>
                      <a:pPr algn="l"/>
                      <a:r>
                        <a:rPr lang="en-AU" sz="900" b="1" dirty="0">
                          <a:effectLst/>
                          <a:latin typeface="Arial Nova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plementary Table 2</a:t>
                      </a: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900" b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900" b="1" dirty="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AU" sz="900" b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500" b="1" dirty="0">
                        <a:latin typeface="Arial Nova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011941"/>
                  </a:ext>
                </a:extLst>
              </a:tr>
              <a:tr h="414764"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>
                          <a:effectLst/>
                        </a:rPr>
                        <a:t>Bead Supplier</a:t>
                      </a:r>
                      <a:endParaRPr lang="en-AU" sz="900" b="1" dirty="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</a:rPr>
                        <a:t>Bead Region</a:t>
                      </a:r>
                      <a:endParaRPr lang="en-AU" sz="900" b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>
                          <a:effectLst/>
                        </a:rPr>
                        <a:t>Bead Catalogue Number</a:t>
                      </a:r>
                      <a:endParaRPr lang="en-AU" sz="900" b="1" dirty="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</a:rPr>
                        <a:t>RBD Recombinant Protein</a:t>
                      </a:r>
                      <a:endParaRPr lang="en-AU" sz="900" b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>
                          <a:effectLst/>
                        </a:rPr>
                        <a:t>Protein Coupled/1x10^7 beads</a:t>
                      </a:r>
                      <a:endParaRPr lang="en-US" sz="1500" b="1">
                        <a:latin typeface="Arial Nova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7982407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6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2006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E406W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5564593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Biorad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07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K417N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1736262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Biorad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9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09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Ancestral wild-type (WT)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2352925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2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12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Y453F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8970649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3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13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R403K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199548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5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15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G446S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4962426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6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2016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G446V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737897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8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18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L455F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7987504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20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20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A475V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4665330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22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22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G476S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9867369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25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25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S477I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1243963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26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26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S477N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0841434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29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29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N439K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4379810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0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0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T478I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030948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3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3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N501T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5529363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4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4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G485R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7656206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5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5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Q493K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0281452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7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7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S494L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053033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6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6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V483A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736202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8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8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E484A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8508255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39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39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E484D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953199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42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42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E484K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3181361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44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44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F490S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3751765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46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45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N501S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1952721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47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47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S477R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1341520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48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48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Y505W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5213348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50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2050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F486L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3170353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5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51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Q493L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4445714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52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52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S494P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9718837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53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53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N501Y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491271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55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55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T478K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811039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6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61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N501Y, E484K, K417N (B.1.251; Beta)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472098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62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62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V503F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0713885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64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64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K417T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0438257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0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0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L452R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1066443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2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2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E484Q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9117837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3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3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N501Y, E484K, K417T (P1; Gamma)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8273026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4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4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S477N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5555440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5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5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Y489H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0185622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6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6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L452R E484Q (B.1.617.1; Kappa)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7234741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7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7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A520S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0034518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 err="1">
                          <a:effectLst/>
                        </a:rPr>
                        <a:t>Biorad</a:t>
                      </a:r>
                      <a:endParaRPr lang="en-AU" sz="800" err="1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78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8-01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L452R, T478K (B.1.617.2; Delta)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277710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Biorad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22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8-22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Ancestral RBD (</a:t>
                      </a:r>
                      <a:r>
                        <a:rPr lang="en-AU" sz="800" err="1">
                          <a:effectLst/>
                        </a:rPr>
                        <a:t>SinoBiological</a:t>
                      </a:r>
                      <a:r>
                        <a:rPr lang="en-AU" sz="800">
                          <a:effectLst/>
                        </a:rPr>
                        <a:t>; Catalogue # </a:t>
                      </a:r>
                      <a:r>
                        <a:rPr lang="en-AU" sz="800" b="0" u="none" strike="noStrike" noProof="0">
                          <a:effectLst/>
                        </a:rPr>
                        <a:t>40592-V08H</a:t>
                      </a:r>
                      <a:r>
                        <a:rPr lang="en-AU" sz="800">
                          <a:effectLst/>
                        </a:rPr>
                        <a:t>)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100ug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4187716"/>
                  </a:ext>
                </a:extLst>
              </a:tr>
              <a:tr h="191753"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Biorad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55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MC10078-55</a:t>
                      </a:r>
                      <a:endParaRPr lang="en-AU" sz="80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>
                          <a:effectLst/>
                        </a:rPr>
                        <a:t>Omicron RBD BA.2 (</a:t>
                      </a:r>
                      <a:r>
                        <a:rPr lang="en-AU" sz="800" err="1">
                          <a:effectLst/>
                        </a:rPr>
                        <a:t>SinoBiological</a:t>
                      </a:r>
                      <a:r>
                        <a:rPr lang="en-AU" sz="800">
                          <a:effectLst/>
                        </a:rPr>
                        <a:t>; Catalogue #40592-V08H123)</a:t>
                      </a:r>
                      <a:endParaRPr lang="en-AU" sz="800">
                        <a:effectLst/>
                        <a:latin typeface="Arial Nova"/>
                        <a:ea typeface="Calibri" panose="020F0502020204030204" pitchFamily="34" charset="0"/>
                        <a:cs typeface="Times New Roman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800" dirty="0">
                          <a:effectLst/>
                        </a:rPr>
                        <a:t>100ug</a:t>
                      </a:r>
                      <a:endParaRPr lang="en-AU" sz="800" dirty="0">
                        <a:effectLst/>
                        <a:latin typeface="Arial Nova" panose="020B050402020202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248" marR="4524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70868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66339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DDA1208-4303-ABDA-29C6-553143D606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2824252"/>
              </p:ext>
            </p:extLst>
          </p:nvPr>
        </p:nvGraphicFramePr>
        <p:xfrm>
          <a:off x="398549" y="470557"/>
          <a:ext cx="6060902" cy="876053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145294">
                  <a:extLst>
                    <a:ext uri="{9D8B030D-6E8A-4147-A177-3AD203B41FA5}">
                      <a16:colId xmlns:a16="http://schemas.microsoft.com/office/drawing/2014/main" val="3327263053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445480523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1164731737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1026333738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3075483990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2613063654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2642610759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1956673146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1412928984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3290153610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240052703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901898270"/>
                    </a:ext>
                  </a:extLst>
                </a:gridCol>
                <a:gridCol w="409634">
                  <a:extLst>
                    <a:ext uri="{9D8B030D-6E8A-4147-A177-3AD203B41FA5}">
                      <a16:colId xmlns:a16="http://schemas.microsoft.com/office/drawing/2014/main" val="2263712902"/>
                    </a:ext>
                  </a:extLst>
                </a:gridCol>
              </a:tblGrid>
              <a:tr h="190213">
                <a:tc gridSpan="13">
                  <a:txBody>
                    <a:bodyPr/>
                    <a:lstStyle/>
                    <a:p>
                      <a:pPr algn="l" fontAlgn="b"/>
                      <a:r>
                        <a:rPr lang="en-AU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ementary Table 3</a:t>
                      </a: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7991653"/>
                  </a:ext>
                </a:extLst>
              </a:tr>
              <a:tr h="73908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 dirty="0">
                          <a:effectLst/>
                        </a:rPr>
                        <a:t>Dunn's multiple comparisons test</a:t>
                      </a:r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IgG Rank sum diff.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IgG Summary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IgG Adjusted P Value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ACE Rank sum diff.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ACE Summary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ACE Adjusted P Value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 dirty="0">
                          <a:effectLst/>
                        </a:rPr>
                        <a:t>FcR2a Rank sum diff.</a:t>
                      </a:r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>
                          <a:effectLst/>
                        </a:rPr>
                        <a:t>FcR2a Summary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 dirty="0">
                          <a:effectLst/>
                        </a:rPr>
                        <a:t>FcR2a Adjusted P Value</a:t>
                      </a:r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 dirty="0">
                          <a:effectLst/>
                        </a:rPr>
                        <a:t>FcR3a Rank sum diff.</a:t>
                      </a:r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 dirty="0">
                          <a:effectLst/>
                        </a:rPr>
                        <a:t>FcR3a Summary</a:t>
                      </a:r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b="1" u="none" strike="noStrike" dirty="0">
                          <a:effectLst/>
                        </a:rPr>
                        <a:t>FcR3a Adjusted P Value</a:t>
                      </a:r>
                      <a:endParaRPr lang="en-AU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0195448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Delta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5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484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61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377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9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63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57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103707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Kappa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1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39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97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9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4789025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Beta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1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27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3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6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7158654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Gamma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4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5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6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3277474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K417T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3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7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224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8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4208910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Y505W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2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7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0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8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2883281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F486L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204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42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9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929199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E484A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6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2158489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S494P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65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39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97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339352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Q493K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46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732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8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136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88893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L452R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7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04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42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354804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T478K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7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21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0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1234949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E484Q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2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5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3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0384154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T478I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4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96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51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3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7887685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N501Y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0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9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1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2529575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N403K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5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577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4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57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7432284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L455F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7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219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3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4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7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635160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V483A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2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16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29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10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3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3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8750552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N501S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2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13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7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163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24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13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2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14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2985993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N439K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3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0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43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3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6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0436850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G476S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4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3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5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1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06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26998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Y489H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7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0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36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0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2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8424995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Y453F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8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0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8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0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9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8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922463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K417N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5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1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07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3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1708871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A475V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1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4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1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29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388834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A520S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133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2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8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4844523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V503F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6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6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0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7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180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6409119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Q493L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6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01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0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4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3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286620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S477N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9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4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716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3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9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1131919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E484D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2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1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26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3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4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4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2540633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S477R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08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7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16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5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88315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S477I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28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9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9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1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5024372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G446V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39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31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44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8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0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080356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G446S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6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87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1058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4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0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4905561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E484K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90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119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6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6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2965958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F490S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02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-42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ns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gt;0.9999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8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35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632369"/>
                  </a:ext>
                </a:extLst>
              </a:tr>
              <a:tr h="211655"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b="1" u="none" strike="noStrike">
                          <a:effectLst/>
                        </a:rPr>
                        <a:t>Ancestral vs. N501T</a:t>
                      </a:r>
                      <a:endParaRPr lang="en-AU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9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260.5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0.0013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50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&lt;0.0001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447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>
                          <a:effectLst/>
                        </a:rPr>
                        <a:t>****</a:t>
                      </a:r>
                      <a:endParaRPr lang="en-AU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700" u="none" strike="noStrike" dirty="0">
                          <a:effectLst/>
                        </a:rPr>
                        <a:t>&lt;0.0001</a:t>
                      </a:r>
                      <a:endParaRPr lang="en-AU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771" marR="4771" marT="47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64745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58236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33</TotalTime>
  <Words>1690</Words>
  <Application>Microsoft Macintosh PowerPoint</Application>
  <PresentationFormat>A4 Paper (210x297 mm)</PresentationFormat>
  <Paragraphs>1176</Paragraphs>
  <Slides>12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21" baseType="lpstr">
      <vt:lpstr>Arial</vt:lpstr>
      <vt:lpstr>Arial Nova</vt:lpstr>
      <vt:lpstr>Arial Nova Cond</vt:lpstr>
      <vt:lpstr>Calibri</vt:lpstr>
      <vt:lpstr>Calibri Light</vt:lpstr>
      <vt:lpstr>Palatino Linotype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 Chung</dc:creator>
  <cp:lastModifiedBy>Amy Chung</cp:lastModifiedBy>
  <cp:revision>11</cp:revision>
  <cp:lastPrinted>2022-07-05T07:58:00Z</cp:lastPrinted>
  <dcterms:created xsi:type="dcterms:W3CDTF">2022-07-05T07:54:52Z</dcterms:created>
  <dcterms:modified xsi:type="dcterms:W3CDTF">2023-06-13T07:14:01Z</dcterms:modified>
</cp:coreProperties>
</file>